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3" r:id="rId2"/>
    <p:sldId id="257" r:id="rId3"/>
    <p:sldId id="284" r:id="rId4"/>
    <p:sldId id="260" r:id="rId5"/>
    <p:sldId id="274" r:id="rId6"/>
    <p:sldId id="266" r:id="rId7"/>
    <p:sldId id="272" r:id="rId8"/>
    <p:sldId id="278" r:id="rId9"/>
    <p:sldId id="283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711"/>
    <p:restoredTop sz="70983" autoAdjust="0"/>
  </p:normalViewPr>
  <p:slideViewPr>
    <p:cSldViewPr snapToGrid="0" snapToObjects="1">
      <p:cViewPr varScale="1">
        <p:scale>
          <a:sx n="72" d="100"/>
          <a:sy n="72" d="100"/>
        </p:scale>
        <p:origin x="2528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07F1B9-F842-8F4B-8705-B1090107AFC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67677C-4F8E-BF4F-A0F1-3049FD1E223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517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1: Patient and molecular information of PDXs</a:t>
            </a:r>
            <a:r>
              <a:rPr lang="en-US" baseline="0" dirty="0"/>
              <a:t> implanted into HIS-BRGS mice and treated with </a:t>
            </a:r>
            <a:r>
              <a:rPr lang="en-US" baseline="0" dirty="0" err="1"/>
              <a:t>cabozantinib</a:t>
            </a:r>
            <a:r>
              <a:rPr lang="en-US" baseline="0" dirty="0"/>
              <a:t> and </a:t>
            </a:r>
            <a:r>
              <a:rPr lang="en-US" baseline="0" dirty="0" err="1"/>
              <a:t>nivolumab</a:t>
            </a:r>
            <a:r>
              <a:rPr lang="en-US" baseline="0" dirty="0"/>
              <a:t>. Far right column indicates relative tumor growth response in the HIS-model to combination treatment (</a:t>
            </a:r>
            <a:r>
              <a:rPr lang="en-US" baseline="0" dirty="0" err="1"/>
              <a:t>Cabo</a:t>
            </a:r>
            <a:r>
              <a:rPr lang="en-US" baseline="0" dirty="0"/>
              <a:t>/</a:t>
            </a:r>
            <a:r>
              <a:rPr lang="en-US" baseline="0" dirty="0" err="1"/>
              <a:t>Nivo</a:t>
            </a:r>
            <a:r>
              <a:rPr lang="en-US" baseline="0" dirty="0"/>
              <a:t>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854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Experimental Details for CRC MSS</a:t>
            </a:r>
            <a:r>
              <a:rPr lang="en-US" baseline="0" dirty="0"/>
              <a:t> PDXs implanted into HIS-BRGS mice including experimental kinetics and human </a:t>
            </a:r>
            <a:r>
              <a:rPr lang="en-US" baseline="0" dirty="0" err="1"/>
              <a:t>chimerism</a:t>
            </a:r>
            <a:r>
              <a:rPr lang="en-US" baseline="0" dirty="0"/>
              <a:t> details as measured in peripheral blood (PBL) prior to tumor injection and in the spleen (SP) at harvest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56790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. Frequency of total Human (hCD45+ of mouse</a:t>
            </a:r>
            <a:r>
              <a:rPr lang="en-US" baseline="0" dirty="0"/>
              <a:t> +human CD45, closed symbols</a:t>
            </a:r>
            <a:r>
              <a:rPr lang="en-US" dirty="0"/>
              <a:t>) and</a:t>
            </a:r>
            <a:r>
              <a:rPr lang="en-US" baseline="0" dirty="0"/>
              <a:t> human T cells (hCD3+ of hCD45+, open symbols)</a:t>
            </a:r>
            <a:r>
              <a:rPr lang="en-US" dirty="0"/>
              <a:t> in blood at 14-16 weeks post engraftment, and prior to injection of PDX, as indicated in graph title. Each dot represents data from a single HIS-BRGS</a:t>
            </a:r>
            <a:r>
              <a:rPr lang="en-US" baseline="0" dirty="0"/>
              <a:t> mouse and allocated into their study treatment groups (V=vehicle, black; N=</a:t>
            </a:r>
            <a:r>
              <a:rPr lang="en-US" baseline="0" dirty="0" err="1"/>
              <a:t>Nivolumab</a:t>
            </a:r>
            <a:r>
              <a:rPr lang="en-US" baseline="0" dirty="0"/>
              <a:t>, blue; </a:t>
            </a:r>
            <a:r>
              <a:rPr lang="en-US" baseline="0" dirty="0" err="1"/>
              <a:t>Ca</a:t>
            </a:r>
            <a:r>
              <a:rPr lang="en-US" baseline="0" dirty="0"/>
              <a:t>=</a:t>
            </a:r>
            <a:r>
              <a:rPr lang="en-US" baseline="0" dirty="0" err="1"/>
              <a:t>cabozantinib</a:t>
            </a:r>
            <a:r>
              <a:rPr lang="en-US" baseline="0" dirty="0"/>
              <a:t>, green; </a:t>
            </a:r>
            <a:r>
              <a:rPr lang="en-US" baseline="0" dirty="0" err="1"/>
              <a:t>Ca</a:t>
            </a:r>
            <a:r>
              <a:rPr lang="en-US" baseline="0" dirty="0"/>
              <a:t>/N=combination of </a:t>
            </a:r>
            <a:r>
              <a:rPr lang="en-US" baseline="0" dirty="0" err="1"/>
              <a:t>nivolumab</a:t>
            </a:r>
            <a:r>
              <a:rPr lang="en-US" baseline="0" dirty="0"/>
              <a:t> and </a:t>
            </a:r>
            <a:r>
              <a:rPr lang="en-US" baseline="0" dirty="0" err="1"/>
              <a:t>cabozantinib</a:t>
            </a:r>
            <a:r>
              <a:rPr lang="en-US" baseline="0" dirty="0"/>
              <a:t>, red). “All PDX” illustrate data from the 4 PDX studies plotted on one graph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2072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: Analysis of human immune subsets in HIS-CRC-BRGS</a:t>
            </a:r>
            <a:r>
              <a:rPr lang="en-US" baseline="0" dirty="0"/>
              <a:t> mice bearing CRC tumors. A) </a:t>
            </a:r>
            <a:r>
              <a:rPr lang="en-US" dirty="0"/>
              <a:t>Flow </a:t>
            </a:r>
            <a:r>
              <a:rPr lang="en-US" dirty="0" err="1"/>
              <a:t>cytometry</a:t>
            </a:r>
            <a:r>
              <a:rPr lang="en-US" dirty="0"/>
              <a:t> gating examples in a spleen and tumor of a HIS-mouse</a:t>
            </a:r>
            <a:r>
              <a:rPr lang="en-US" baseline="0" dirty="0"/>
              <a:t> showing gating for mouse (mCD45+), human (hCD45+), human T (hCD3+ and CD4+ subset), B (CD19+), and myeloid cells (hCD11b/CD11c/CD14/CD33) lineages. Arrows indicate the parent gate. B) Fewer mouse CD45+ cells in the spleen (left) but not the tumor (right) of HIS-mice treated with </a:t>
            </a:r>
            <a:r>
              <a:rPr lang="en-US" baseline="0" dirty="0" err="1"/>
              <a:t>cabozantinib</a:t>
            </a:r>
            <a:r>
              <a:rPr lang="en-US" baseline="0" dirty="0"/>
              <a:t>, alone or in combination with </a:t>
            </a:r>
            <a:r>
              <a:rPr lang="en-US" baseline="0" dirty="0" err="1"/>
              <a:t>nivolumab</a:t>
            </a:r>
            <a:r>
              <a:rPr lang="en-US" baseline="0" dirty="0"/>
              <a:t>. C) The number of human (hCD45+), CD3+ total T and CD4+ and CD8+ T cell subsets in the lymph nodes (LN) and spleens (SP) of HIS-CRC-BRGS-mice showing combined data of the four PDX studies. Each dot represents data from an individual HIS-CRC-mouse, lines represent </a:t>
            </a:r>
            <a:r>
              <a:rPr lang="en-US" baseline="0" dirty="0" err="1"/>
              <a:t>mean±SEM</a:t>
            </a:r>
            <a:r>
              <a:rPr lang="en-US" baseline="0" dirty="0"/>
              <a:t>. *p&lt;0.05, ** p&lt;0.01, ***p&lt;0.001 [</a:t>
            </a:r>
            <a:r>
              <a:rPr lang="en-US" i="1" baseline="0" dirty="0"/>
              <a:t>Welch’s two-tailed, unpaired t-test</a:t>
            </a:r>
            <a:r>
              <a:rPr lang="en-US" baseline="0" dirty="0"/>
              <a:t>]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2684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3: Flow </a:t>
            </a:r>
            <a:r>
              <a:rPr lang="en-US" dirty="0" err="1"/>
              <a:t>cytometric</a:t>
            </a:r>
            <a:r>
              <a:rPr lang="en-US" dirty="0"/>
              <a:t> examples illustrating analyses</a:t>
            </a:r>
            <a:r>
              <a:rPr lang="en-US" baseline="0" dirty="0"/>
              <a:t> of distinct human T cell phenotypes </a:t>
            </a:r>
            <a:r>
              <a:rPr lang="en-US" dirty="0"/>
              <a:t>in spleen and tumor of HIS-CRC-BRGS mouse. A) Activated T cells expressing HLA-DR, B) T naïve and memory populations defined</a:t>
            </a:r>
            <a:r>
              <a:rPr lang="en-US" baseline="0" dirty="0"/>
              <a:t> by CCR7+CD45RA+ (Naïve), CCR7+CD45RA- (</a:t>
            </a:r>
            <a:r>
              <a:rPr lang="en-US" baseline="0" dirty="0" err="1"/>
              <a:t>Tcm</a:t>
            </a:r>
            <a:r>
              <a:rPr lang="en-US" baseline="0" dirty="0"/>
              <a:t>), CCR7-CD45RA- (Tem) and CCR7-CD45RA+ (TEMRA), T cells producing cytotoxic </a:t>
            </a:r>
            <a:r>
              <a:rPr lang="en-US" baseline="0" dirty="0" err="1"/>
              <a:t>Granzyme</a:t>
            </a:r>
            <a:r>
              <a:rPr lang="en-US" baseline="0" dirty="0"/>
              <a:t> B (C), </a:t>
            </a:r>
            <a:r>
              <a:rPr lang="en-US" baseline="0" dirty="0" err="1"/>
              <a:t>TNF</a:t>
            </a:r>
            <a:r>
              <a:rPr lang="en-US" baseline="0" dirty="0" err="1">
                <a:latin typeface="Symbol" charset="2"/>
                <a:cs typeface="Symbol" charset="2"/>
              </a:rPr>
              <a:t>a</a:t>
            </a:r>
            <a:r>
              <a:rPr lang="en-US" baseline="0" dirty="0"/>
              <a:t> or </a:t>
            </a:r>
            <a:r>
              <a:rPr lang="en-US" baseline="0" dirty="0" err="1"/>
              <a:t>IFN</a:t>
            </a:r>
            <a:r>
              <a:rPr lang="en-US" baseline="0" dirty="0" err="1">
                <a:latin typeface="Symbol" charset="2"/>
                <a:cs typeface="Symbol" charset="2"/>
              </a:rPr>
              <a:t>g</a:t>
            </a:r>
            <a:r>
              <a:rPr lang="en-US" baseline="0" dirty="0"/>
              <a:t> (D) molecules, or E) </a:t>
            </a:r>
            <a:r>
              <a:rPr lang="en-US" baseline="0" dirty="0" err="1"/>
              <a:t>Tregs</a:t>
            </a:r>
            <a:r>
              <a:rPr lang="en-US" baseline="0" dirty="0"/>
              <a:t> (CD25+FoxP3+). Population above graph indicates the parent gate. Expression of HLA-DR MHC Class II on human B  and myeloid cells are shown on bottom plots in (A). Positive </a:t>
            </a:r>
            <a:r>
              <a:rPr lang="en-US" baseline="0" dirty="0" err="1"/>
              <a:t>Control”PC</a:t>
            </a:r>
            <a:r>
              <a:rPr lang="en-US" baseline="0" dirty="0"/>
              <a:t>” human PBMCs, either </a:t>
            </a:r>
            <a:r>
              <a:rPr lang="en-US" baseline="0" dirty="0" err="1"/>
              <a:t>unstimulated</a:t>
            </a:r>
            <a:r>
              <a:rPr lang="en-US" baseline="0" dirty="0"/>
              <a:t> or stimulated with mitogen, to assess production of </a:t>
            </a:r>
            <a:r>
              <a:rPr lang="en-US" baseline="0" dirty="0" err="1"/>
              <a:t>IFN</a:t>
            </a:r>
            <a:r>
              <a:rPr lang="en-US" baseline="0" dirty="0" err="1">
                <a:latin typeface="Symbol" charset="2"/>
                <a:cs typeface="Symbol" charset="2"/>
              </a:rPr>
              <a:t>g</a:t>
            </a:r>
            <a:r>
              <a:rPr lang="en-US" baseline="0" dirty="0"/>
              <a:t> and </a:t>
            </a:r>
            <a:r>
              <a:rPr lang="en-US" baseline="0" dirty="0" err="1"/>
              <a:t>TNF</a:t>
            </a:r>
            <a:r>
              <a:rPr lang="en-US" baseline="0" dirty="0" err="1">
                <a:latin typeface="Symbol" charset="2"/>
                <a:cs typeface="Symbol" charset="2"/>
              </a:rPr>
              <a:t>a</a:t>
            </a:r>
            <a:r>
              <a:rPr lang="en-US" baseline="0" dirty="0"/>
              <a:t> are shown in Column D, bottom two panels.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33076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4. Comparison</a:t>
            </a:r>
            <a:r>
              <a:rPr lang="en-US" baseline="0" dirty="0"/>
              <a:t> of TKI and ICB inhibitor combinations, </a:t>
            </a:r>
            <a:r>
              <a:rPr lang="en-US" baseline="0" dirty="0" err="1"/>
              <a:t>cobmetinib+atezolizumab</a:t>
            </a:r>
            <a:r>
              <a:rPr lang="en-US" baseline="0" dirty="0"/>
              <a:t> and </a:t>
            </a:r>
            <a:r>
              <a:rPr lang="en-US" baseline="0" dirty="0" err="1"/>
              <a:t>cabozantinib+nivolumab</a:t>
            </a:r>
            <a:r>
              <a:rPr lang="en-US" baseline="0" dirty="0"/>
              <a:t>, for CRC treatment in HIS-BRGS PDX models.  A) Experimental replicates including number of HIS-BRGS mice injected with PDX CRC307P in each flank for each treatment group, number that died, removed due to low </a:t>
            </a:r>
            <a:r>
              <a:rPr lang="en-US" baseline="0" dirty="0" err="1"/>
              <a:t>chimerism</a:t>
            </a:r>
            <a:r>
              <a:rPr lang="en-US" baseline="0" dirty="0"/>
              <a:t> at end of study. B) Tumor growth as measured by tumor volumes (left), SGR (middle) and tumor weights at harvest (right). C-E) Immune correlates as measured in tumor or lymph at harvest: C) frequency of mouse CD45+ (myeloid) cells in tumor, D) Relative cell # of  human CD4+ and CD8+ T cells in lymph nodes (LN) and spleen (SP); E) # of </a:t>
            </a:r>
            <a:r>
              <a:rPr lang="en-US" baseline="0" dirty="0" err="1"/>
              <a:t>plasmacytoid</a:t>
            </a:r>
            <a:r>
              <a:rPr lang="en-US" baseline="0" dirty="0"/>
              <a:t> dendritic cells (</a:t>
            </a:r>
            <a:r>
              <a:rPr lang="en-US" baseline="0" dirty="0" err="1"/>
              <a:t>pDC</a:t>
            </a:r>
            <a:r>
              <a:rPr lang="en-US" baseline="0" dirty="0"/>
              <a:t>, Lin-, HLA-DR+) and frequency of HLA-DR+ human myeloid cells in tumor; and F) mean fluorescence intensity of PD-1 on tumor cells (</a:t>
            </a:r>
            <a:r>
              <a:rPr lang="en-US" baseline="0" dirty="0" err="1"/>
              <a:t>EpCam</a:t>
            </a:r>
            <a:r>
              <a:rPr lang="en-US" baseline="0" dirty="0"/>
              <a:t>+). Each dot represents data from an individual HIS-CRC307P-mouse, lines represent </a:t>
            </a:r>
            <a:r>
              <a:rPr lang="en-US" baseline="0" dirty="0" err="1"/>
              <a:t>mean±SEM</a:t>
            </a:r>
            <a:r>
              <a:rPr lang="en-US" baseline="0" dirty="0"/>
              <a:t>. *p&lt;0.05, ** p&lt;0.01, ***p&lt;0.001 [</a:t>
            </a:r>
            <a:r>
              <a:rPr lang="en-US" i="1" baseline="0" dirty="0"/>
              <a:t>Welch’s two-tailed, unpaired t-test</a:t>
            </a:r>
            <a:r>
              <a:rPr lang="en-US" baseline="0" dirty="0"/>
              <a:t>]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1663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5. A)</a:t>
            </a:r>
            <a:r>
              <a:rPr lang="en-US" baseline="0" dirty="0"/>
              <a:t> Frequency of mouse CD45+ myeloid cells in tumors of HIS-CRC-BRGS mice according to treatment (V=vehicle, N=</a:t>
            </a:r>
            <a:r>
              <a:rPr lang="en-US" baseline="0" dirty="0" err="1"/>
              <a:t>nivolumab</a:t>
            </a:r>
            <a:r>
              <a:rPr lang="en-US" baseline="0" dirty="0"/>
              <a:t>, </a:t>
            </a:r>
            <a:r>
              <a:rPr lang="en-US" baseline="0" dirty="0" err="1"/>
              <a:t>Ca</a:t>
            </a:r>
            <a:r>
              <a:rPr lang="en-US" baseline="0" dirty="0"/>
              <a:t>=</a:t>
            </a:r>
            <a:r>
              <a:rPr lang="en-US" baseline="0" dirty="0" err="1"/>
              <a:t>cabozatinib</a:t>
            </a:r>
            <a:r>
              <a:rPr lang="en-US" baseline="0" dirty="0"/>
              <a:t>, </a:t>
            </a:r>
            <a:r>
              <a:rPr lang="en-US" baseline="0" dirty="0" err="1"/>
              <a:t>Ca</a:t>
            </a:r>
            <a:r>
              <a:rPr lang="en-US" baseline="0" dirty="0"/>
              <a:t>/N=</a:t>
            </a:r>
            <a:r>
              <a:rPr lang="en-US" baseline="0" dirty="0" err="1"/>
              <a:t>cabozatinib+nivolumab</a:t>
            </a:r>
            <a:r>
              <a:rPr lang="en-US" baseline="0" dirty="0"/>
              <a:t>) among responding and non-responding tumors. Each dot represents data from an individual HIS-CRC-mouse, lines represent </a:t>
            </a:r>
            <a:r>
              <a:rPr lang="en-US" baseline="0" dirty="0" err="1"/>
              <a:t>means±SEM</a:t>
            </a:r>
            <a:r>
              <a:rPr lang="en-US" baseline="0" dirty="0"/>
              <a:t>. *p&lt;0.05, ** p&lt;0.01, ***p&lt;0.001 [</a:t>
            </a:r>
            <a:r>
              <a:rPr lang="en-US" i="1" baseline="0" dirty="0"/>
              <a:t>Welch’s two-tailed, unpaired t-test</a:t>
            </a:r>
            <a:r>
              <a:rPr lang="en-US" baseline="0" dirty="0"/>
              <a:t>]. B) </a:t>
            </a:r>
            <a:r>
              <a:rPr lang="en-US" baseline="0" dirty="0" err="1"/>
              <a:t>Immunotypes</a:t>
            </a:r>
            <a:r>
              <a:rPr lang="en-US" baseline="0" dirty="0"/>
              <a:t> among CD4+ T cells (top) and CD8+ T cell (bottom) populations relative to tumor specific growth rate (SGR) for expression of </a:t>
            </a:r>
            <a:r>
              <a:rPr lang="en-US" baseline="0" dirty="0" err="1"/>
              <a:t>Granzyme</a:t>
            </a:r>
            <a:r>
              <a:rPr lang="en-US" baseline="0" dirty="0"/>
              <a:t> B (</a:t>
            </a:r>
            <a:r>
              <a:rPr lang="en-US" baseline="0" dirty="0" err="1"/>
              <a:t>GrB</a:t>
            </a:r>
            <a:r>
              <a:rPr lang="en-US" baseline="0" dirty="0"/>
              <a:t>+), CD45RA-CCR7- (Tem), CD45RA-CCR7+ (</a:t>
            </a:r>
            <a:r>
              <a:rPr lang="en-US" baseline="0" dirty="0" err="1"/>
              <a:t>Tcm</a:t>
            </a:r>
            <a:r>
              <a:rPr lang="en-US" baseline="0" dirty="0"/>
              <a:t>) or TIM-3. Data from mice treated with combination therapies.  </a:t>
            </a:r>
            <a:r>
              <a:rPr lang="en-US" i="1" baseline="0" dirty="0"/>
              <a:t>[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near regression analysis, R-squared score (R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P value (P) in bold if P&lt;0.05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11257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6. Correlation</a:t>
            </a:r>
            <a:r>
              <a:rPr lang="en-US" baseline="0" dirty="0"/>
              <a:t> of </a:t>
            </a:r>
            <a:r>
              <a:rPr lang="en-US" baseline="0" dirty="0" err="1"/>
              <a:t>immunotypes</a:t>
            </a:r>
            <a:r>
              <a:rPr lang="en-US" baseline="0" dirty="0"/>
              <a:t> and tumor growth rates (SGR) in HIS-CRC-BRGS mice treated with single-agent </a:t>
            </a:r>
            <a:r>
              <a:rPr lang="en-US" baseline="0" dirty="0" err="1"/>
              <a:t>cabozatinib</a:t>
            </a:r>
            <a:r>
              <a:rPr lang="en-US" baseline="0" dirty="0"/>
              <a:t>. Immune parameters were measured in CRC PDXs (172, 295, 335, 307M) explanted from HIS-BRGS mice using flow </a:t>
            </a:r>
            <a:r>
              <a:rPr lang="en-US" baseline="0" dirty="0" err="1"/>
              <a:t>cytometry</a:t>
            </a:r>
            <a:r>
              <a:rPr lang="en-US" baseline="0" dirty="0"/>
              <a:t> and plotted versus the tumor specific growth rate (SGR). Individual immune parameters are indicated above each plot and are gated on (top row):  total human cells unless otherwise indicated in parenthesis or as indicated by population underlined for each row. T effector (Tem) and central memory (</a:t>
            </a:r>
            <a:r>
              <a:rPr lang="en-US" baseline="0" dirty="0" err="1"/>
              <a:t>Tcm</a:t>
            </a:r>
            <a:r>
              <a:rPr lang="en-US" baseline="0" dirty="0"/>
              <a:t>) populations were determined by CCR7 and CD45RO/RA staining. The MFI of MHC HLA Class I and II as well as PD-L1 was restricted to the </a:t>
            </a:r>
            <a:r>
              <a:rPr lang="en-US" baseline="0" dirty="0" err="1"/>
              <a:t>EpCAM</a:t>
            </a:r>
            <a:r>
              <a:rPr lang="en-US" baseline="0" dirty="0"/>
              <a:t>+ tumor cells and normalized to expression on human B cells from same day. </a:t>
            </a:r>
            <a:r>
              <a:rPr lang="en-US" i="1" baseline="0" dirty="0"/>
              <a:t>[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near regression analysis, R-squared score (R</a:t>
            </a:r>
            <a:r>
              <a:rPr lang="en-US" sz="1200" i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nd P value (P) in bold if P&lt;0.05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]</a:t>
            </a:r>
            <a:r>
              <a:rPr lang="en-US" dirty="0">
                <a:effectLst/>
              </a:rPr>
              <a:t> </a:t>
            </a:r>
            <a:endParaRPr lang="en-US" dirty="0"/>
          </a:p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67677C-4F8E-BF4F-A0F1-3049FD1E223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7804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667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210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994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938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239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690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317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207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103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196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12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85537-985B-9D42-9C3D-EEB08F7E701D}" type="datetimeFigureOut">
              <a:rPr lang="en-US" smtClean="0"/>
              <a:t>9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49CB9-F9A1-BB48-807A-DC703B314E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07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13" Type="http://schemas.openxmlformats.org/officeDocument/2006/relationships/image" Target="../media/image16.tiff"/><Relationship Id="rId18" Type="http://schemas.openxmlformats.org/officeDocument/2006/relationships/image" Target="../media/image21.emf"/><Relationship Id="rId3" Type="http://schemas.openxmlformats.org/officeDocument/2006/relationships/image" Target="../media/image6.tiff"/><Relationship Id="rId21" Type="http://schemas.openxmlformats.org/officeDocument/2006/relationships/image" Target="../media/image24.emf"/><Relationship Id="rId7" Type="http://schemas.openxmlformats.org/officeDocument/2006/relationships/image" Target="../media/image10.tiff"/><Relationship Id="rId12" Type="http://schemas.openxmlformats.org/officeDocument/2006/relationships/image" Target="../media/image15.tiff"/><Relationship Id="rId17" Type="http://schemas.openxmlformats.org/officeDocument/2006/relationships/image" Target="../media/image20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9.tiff"/><Relationship Id="rId20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11" Type="http://schemas.openxmlformats.org/officeDocument/2006/relationships/image" Target="../media/image14.tiff"/><Relationship Id="rId5" Type="http://schemas.openxmlformats.org/officeDocument/2006/relationships/image" Target="../media/image8.tiff"/><Relationship Id="rId15" Type="http://schemas.openxmlformats.org/officeDocument/2006/relationships/image" Target="../media/image18.tiff"/><Relationship Id="rId10" Type="http://schemas.openxmlformats.org/officeDocument/2006/relationships/image" Target="../media/image13.tiff"/><Relationship Id="rId19" Type="http://schemas.openxmlformats.org/officeDocument/2006/relationships/image" Target="../media/image22.emf"/><Relationship Id="rId4" Type="http://schemas.openxmlformats.org/officeDocument/2006/relationships/image" Target="../media/image7.tiff"/><Relationship Id="rId9" Type="http://schemas.openxmlformats.org/officeDocument/2006/relationships/image" Target="../media/image12.tiff"/><Relationship Id="rId14" Type="http://schemas.openxmlformats.org/officeDocument/2006/relationships/image" Target="../media/image17.tiff"/><Relationship Id="rId22" Type="http://schemas.openxmlformats.org/officeDocument/2006/relationships/image" Target="../media/image2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tiff"/><Relationship Id="rId3" Type="http://schemas.openxmlformats.org/officeDocument/2006/relationships/image" Target="../media/image26.tiff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4" Type="http://schemas.openxmlformats.org/officeDocument/2006/relationships/image" Target="../media/image27.tiff"/><Relationship Id="rId9" Type="http://schemas.openxmlformats.org/officeDocument/2006/relationships/image" Target="../media/image32.png"/><Relationship Id="rId14" Type="http://schemas.openxmlformats.org/officeDocument/2006/relationships/image" Target="../media/image37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3" Type="http://schemas.openxmlformats.org/officeDocument/2006/relationships/image" Target="../media/image40.emf"/><Relationship Id="rId7" Type="http://schemas.openxmlformats.org/officeDocument/2006/relationships/image" Target="../media/image44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emf"/><Relationship Id="rId11" Type="http://schemas.openxmlformats.org/officeDocument/2006/relationships/image" Target="../media/image48.emf"/><Relationship Id="rId5" Type="http://schemas.openxmlformats.org/officeDocument/2006/relationships/image" Target="../media/image42.emf"/><Relationship Id="rId10" Type="http://schemas.openxmlformats.org/officeDocument/2006/relationships/image" Target="../media/image47.emf"/><Relationship Id="rId4" Type="http://schemas.openxmlformats.org/officeDocument/2006/relationships/image" Target="../media/image41.emf"/><Relationship Id="rId9" Type="http://schemas.openxmlformats.org/officeDocument/2006/relationships/image" Target="../media/image46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3" Type="http://schemas.openxmlformats.org/officeDocument/2006/relationships/image" Target="../media/image49.emf"/><Relationship Id="rId7" Type="http://schemas.openxmlformats.org/officeDocument/2006/relationships/image" Target="../media/image53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emf"/><Relationship Id="rId11" Type="http://schemas.openxmlformats.org/officeDocument/2006/relationships/image" Target="../media/image57.emf"/><Relationship Id="rId5" Type="http://schemas.openxmlformats.org/officeDocument/2006/relationships/image" Target="../media/image51.emf"/><Relationship Id="rId10" Type="http://schemas.openxmlformats.org/officeDocument/2006/relationships/image" Target="../media/image56.emf"/><Relationship Id="rId4" Type="http://schemas.openxmlformats.org/officeDocument/2006/relationships/image" Target="../media/image50.emf"/><Relationship Id="rId9" Type="http://schemas.openxmlformats.org/officeDocument/2006/relationships/image" Target="../media/image55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emf"/><Relationship Id="rId13" Type="http://schemas.openxmlformats.org/officeDocument/2006/relationships/image" Target="../media/image68.emf"/><Relationship Id="rId18" Type="http://schemas.openxmlformats.org/officeDocument/2006/relationships/image" Target="../media/image73.emf"/><Relationship Id="rId3" Type="http://schemas.openxmlformats.org/officeDocument/2006/relationships/image" Target="../media/image58.emf"/><Relationship Id="rId21" Type="http://schemas.openxmlformats.org/officeDocument/2006/relationships/image" Target="../media/image76.emf"/><Relationship Id="rId7" Type="http://schemas.openxmlformats.org/officeDocument/2006/relationships/image" Target="../media/image62.emf"/><Relationship Id="rId12" Type="http://schemas.openxmlformats.org/officeDocument/2006/relationships/image" Target="../media/image67.emf"/><Relationship Id="rId17" Type="http://schemas.openxmlformats.org/officeDocument/2006/relationships/image" Target="../media/image72.emf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71.emf"/><Relationship Id="rId20" Type="http://schemas.openxmlformats.org/officeDocument/2006/relationships/image" Target="../media/image7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emf"/><Relationship Id="rId11" Type="http://schemas.openxmlformats.org/officeDocument/2006/relationships/image" Target="../media/image66.emf"/><Relationship Id="rId24" Type="http://schemas.openxmlformats.org/officeDocument/2006/relationships/image" Target="../media/image79.emf"/><Relationship Id="rId5" Type="http://schemas.openxmlformats.org/officeDocument/2006/relationships/image" Target="../media/image60.emf"/><Relationship Id="rId15" Type="http://schemas.openxmlformats.org/officeDocument/2006/relationships/image" Target="../media/image70.emf"/><Relationship Id="rId23" Type="http://schemas.openxmlformats.org/officeDocument/2006/relationships/image" Target="../media/image78.emf"/><Relationship Id="rId10" Type="http://schemas.openxmlformats.org/officeDocument/2006/relationships/image" Target="../media/image65.emf"/><Relationship Id="rId19" Type="http://schemas.openxmlformats.org/officeDocument/2006/relationships/image" Target="../media/image74.emf"/><Relationship Id="rId4" Type="http://schemas.openxmlformats.org/officeDocument/2006/relationships/image" Target="../media/image59.emf"/><Relationship Id="rId9" Type="http://schemas.openxmlformats.org/officeDocument/2006/relationships/image" Target="../media/image64.emf"/><Relationship Id="rId14" Type="http://schemas.openxmlformats.org/officeDocument/2006/relationships/image" Target="../media/image69.emf"/><Relationship Id="rId22" Type="http://schemas.openxmlformats.org/officeDocument/2006/relationships/image" Target="../media/image7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/>
              <a:t>Supplemental Table I: PDX Information </a:t>
            </a:r>
          </a:p>
        </p:txBody>
      </p:sp>
      <p:graphicFrame>
        <p:nvGraphicFramePr>
          <p:cNvPr id="4" name="Tabla 2">
            <a:extLst>
              <a:ext uri="{FF2B5EF4-FFF2-40B4-BE49-F238E27FC236}">
                <a16:creationId xmlns:a16="http://schemas.microsoft.com/office/drawing/2014/main" id="{5E44E89C-2AFB-3444-808F-0F759399B99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85705555"/>
              </p:ext>
            </p:extLst>
          </p:nvPr>
        </p:nvGraphicFramePr>
        <p:xfrm>
          <a:off x="557708" y="1417638"/>
          <a:ext cx="7819120" cy="5225503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6579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6227">
                  <a:extLst>
                    <a:ext uri="{9D8B030D-6E8A-4147-A177-3AD203B41FA5}">
                      <a16:colId xmlns:a16="http://schemas.microsoft.com/office/drawing/2014/main" val="2770105028"/>
                    </a:ext>
                  </a:extLst>
                </a:gridCol>
                <a:gridCol w="665330">
                  <a:extLst>
                    <a:ext uri="{9D8B030D-6E8A-4147-A177-3AD203B41FA5}">
                      <a16:colId xmlns:a16="http://schemas.microsoft.com/office/drawing/2014/main" val="2761877658"/>
                    </a:ext>
                  </a:extLst>
                </a:gridCol>
                <a:gridCol w="1730387">
                  <a:extLst>
                    <a:ext uri="{9D8B030D-6E8A-4147-A177-3AD203B41FA5}">
                      <a16:colId xmlns:a16="http://schemas.microsoft.com/office/drawing/2014/main" val="3422875765"/>
                    </a:ext>
                  </a:extLst>
                </a:gridCol>
                <a:gridCol w="1650084">
                  <a:extLst>
                    <a:ext uri="{9D8B030D-6E8A-4147-A177-3AD203B41FA5}">
                      <a16:colId xmlns:a16="http://schemas.microsoft.com/office/drawing/2014/main" val="368595707"/>
                    </a:ext>
                  </a:extLst>
                </a:gridCol>
                <a:gridCol w="1169565">
                  <a:extLst>
                    <a:ext uri="{9D8B030D-6E8A-4147-A177-3AD203B41FA5}">
                      <a16:colId xmlns:a16="http://schemas.microsoft.com/office/drawing/2014/main" val="2153511794"/>
                    </a:ext>
                  </a:extLst>
                </a:gridCol>
                <a:gridCol w="116956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986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DX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atient Data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PDX information</a:t>
                      </a:r>
                      <a:endParaRPr lang="es-E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Molecular information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Previous treatments </a:t>
                      </a:r>
                      <a:endParaRPr lang="es-E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sponse in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u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CB-BRGS </a:t>
                      </a: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abo/</a:t>
                      </a: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ivo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159970950"/>
                  </a:ext>
                </a:extLst>
              </a:tr>
              <a:tr h="67311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 201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CRC172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50 YO white mal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Liver metastasis tissue from moderately differentiated stage IV MSS left-colon cance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KRA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 (c.35G&gt;A, p.G12D, GGT&gt;GAT)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5-FU/ capecitabin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Oxaliplatin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ong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82092703"/>
                  </a:ext>
                </a:extLst>
              </a:tr>
              <a:tr h="12359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ct 201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CRC294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33 YO white femal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rimary tumor tissue from poorly differentiated stage III MSS rectal cance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KRA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 (p.G12D c.35G&gt;A)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IK3C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APC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CTNNB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W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5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W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Non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s-ES" sz="1200" b="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200" b="0" baseline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ivo</a:t>
                      </a:r>
                      <a:r>
                        <a:rPr lang="es-ES" sz="1200" b="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Cabo and Combo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25533001"/>
                  </a:ext>
                </a:extLst>
              </a:tr>
              <a:tr h="67311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an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01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CRC335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31 YO white mal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Liver metastasis tissue from moderately differentiated stage IV MSS left-colon cance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WT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K3CA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WT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TNNB1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WT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200" b="0" i="1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53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T 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5-FU/ capecitabin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Oxaliplatin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VEGF inhibito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</a:t>
                      </a: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fference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– </a:t>
                      </a: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or</a:t>
                      </a:r>
                      <a:r>
                        <a:rPr lang="es-ES" sz="1200" b="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200" b="0" baseline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rowth</a:t>
                      </a:r>
                      <a:r>
                        <a:rPr lang="es-ES" sz="1200" b="0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200" b="0" baseline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verall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58880335"/>
                  </a:ext>
                </a:extLst>
              </a:tr>
              <a:tr h="8974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y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01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CRC307M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66 YO white mal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Liver metastasis tissue from moderately differentiated stage IV MSS right-colon cance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KRA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 (p.G12S)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IK3C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W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APC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5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5-FU/ capecitabin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Oxaliplatin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VEGF inhibito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ood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8556058"/>
                  </a:ext>
                </a:extLst>
              </a:tr>
              <a:tr h="89748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an</a:t>
                      </a: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02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C307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66 YO white mal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Primary tumor tissue from moderately differentiated stage IV MSS right-colon cance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KRA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 (p.G12S)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IK3C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W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APC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</a:rPr>
                        <a:t>P5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 mutant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5-FU/ capecitabine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Oxaliplatin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VEGF inhibitor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s-ES" sz="1200" b="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ong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928190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000" dirty="0"/>
              <a:t>Supplemental Table II: Experimental Details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0970390"/>
              </p:ext>
            </p:extLst>
          </p:nvPr>
        </p:nvGraphicFramePr>
        <p:xfrm>
          <a:off x="278746" y="1397000"/>
          <a:ext cx="8412239" cy="4480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7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265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119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8486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95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143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3483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2659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126593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D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ime</a:t>
                      </a:r>
                    </a:p>
                    <a:p>
                      <a:pPr algn="ctr"/>
                      <a:r>
                        <a:rPr lang="en-US" dirty="0" err="1"/>
                        <a:t>Qtr</a:t>
                      </a:r>
                      <a:r>
                        <a:rPr lang="en-US" dirty="0"/>
                        <a:t>/</a:t>
                      </a:r>
                      <a:r>
                        <a:rPr lang="en-US" dirty="0" err="1"/>
                        <a:t>Yr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ge Tumor </a:t>
                      </a:r>
                      <a:r>
                        <a:rPr lang="en-US" dirty="0" err="1"/>
                        <a:t>Inj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# mice</a:t>
                      </a:r>
                    </a:p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um </a:t>
                      </a:r>
                      <a:r>
                        <a:rPr lang="en-US" baseline="0" dirty="0"/>
                        <a:t>Take Rate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Days</a:t>
                      </a:r>
                      <a:r>
                        <a:rPr lang="en-US" baseline="0" dirty="0"/>
                        <a:t> to </a:t>
                      </a:r>
                      <a:r>
                        <a:rPr lang="en-US" baseline="0" dirty="0" err="1"/>
                        <a:t>Tx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ge Harvest (</a:t>
                      </a:r>
                      <a:r>
                        <a:rPr lang="en-US" dirty="0" err="1"/>
                        <a:t>wks</a:t>
                      </a:r>
                      <a:r>
                        <a:rPr lang="en-US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BL</a:t>
                      </a:r>
                      <a:r>
                        <a:rPr lang="en-US" baseline="0" dirty="0"/>
                        <a:t> </a:t>
                      </a:r>
                      <a:r>
                        <a:rPr lang="en-US" baseline="0" dirty="0" err="1"/>
                        <a:t>Chim</a:t>
                      </a:r>
                      <a:r>
                        <a:rPr lang="en-US" baseline="0" dirty="0"/>
                        <a:t> Hu/T pre-tumor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P</a:t>
                      </a:r>
                      <a:r>
                        <a:rPr lang="en-US" baseline="0" dirty="0"/>
                        <a:t> </a:t>
                      </a:r>
                      <a:r>
                        <a:rPr lang="en-US" baseline="0" dirty="0" err="1"/>
                        <a:t>Chim</a:t>
                      </a:r>
                      <a:endParaRPr lang="en-US" baseline="0" dirty="0"/>
                    </a:p>
                    <a:p>
                      <a:pPr algn="ctr"/>
                      <a:r>
                        <a:rPr lang="en-US" baseline="0" dirty="0"/>
                        <a:t>Hu/T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RC17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/20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 21-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err="1"/>
                        <a:t>Inj</a:t>
                      </a:r>
                      <a:r>
                        <a:rPr lang="en-US" sz="1600" dirty="0"/>
                        <a:t>: 18</a:t>
                      </a:r>
                    </a:p>
                    <a:p>
                      <a:r>
                        <a:rPr lang="en-US" sz="1600" dirty="0" err="1"/>
                        <a:t>Harv</a:t>
                      </a:r>
                      <a:r>
                        <a:rPr lang="en-US" sz="1600" dirty="0"/>
                        <a:t>: 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5-28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2% Hu</a:t>
                      </a:r>
                    </a:p>
                    <a:p>
                      <a:r>
                        <a:rPr lang="en-US" dirty="0"/>
                        <a:t>56% 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4% Hu</a:t>
                      </a:r>
                    </a:p>
                    <a:p>
                      <a:r>
                        <a:rPr lang="en-US" dirty="0"/>
                        <a:t>78% 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RC294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/20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9-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err="1"/>
                        <a:t>Inj</a:t>
                      </a:r>
                      <a:r>
                        <a:rPr lang="en-US" sz="1600" dirty="0"/>
                        <a:t>: 23</a:t>
                      </a:r>
                    </a:p>
                    <a:p>
                      <a:r>
                        <a:rPr lang="en-US" sz="1600" dirty="0" err="1"/>
                        <a:t>Harv</a:t>
                      </a:r>
                      <a:r>
                        <a:rPr lang="en-US" sz="1600" dirty="0"/>
                        <a:t>: 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2-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9-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2% Hu</a:t>
                      </a:r>
                    </a:p>
                    <a:p>
                      <a:r>
                        <a:rPr lang="en-US" dirty="0"/>
                        <a:t>27% 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7%</a:t>
                      </a:r>
                      <a:r>
                        <a:rPr lang="en-US" baseline="0" dirty="0"/>
                        <a:t> Hu </a:t>
                      </a:r>
                      <a:r>
                        <a:rPr lang="en-US" dirty="0"/>
                        <a:t>73% 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RC3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/20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-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err="1"/>
                        <a:t>Inj</a:t>
                      </a:r>
                      <a:r>
                        <a:rPr lang="en-US" sz="1600" dirty="0"/>
                        <a:t>: 28</a:t>
                      </a:r>
                    </a:p>
                    <a:p>
                      <a:r>
                        <a:rPr lang="en-US" sz="1600" dirty="0" err="1"/>
                        <a:t>Harv</a:t>
                      </a:r>
                      <a:r>
                        <a:rPr lang="en-US" sz="1600" dirty="0"/>
                        <a:t>: 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4-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45% Hu</a:t>
                      </a:r>
                    </a:p>
                    <a:p>
                      <a:r>
                        <a:rPr lang="en-US" dirty="0"/>
                        <a:t>23% 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2% Hu</a:t>
                      </a:r>
                    </a:p>
                    <a:p>
                      <a:r>
                        <a:rPr lang="en-US" dirty="0"/>
                        <a:t>80% 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RC307M#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/20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8-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err="1"/>
                        <a:t>Inj</a:t>
                      </a:r>
                      <a:r>
                        <a:rPr lang="en-US" sz="1600" dirty="0"/>
                        <a:t>: 27</a:t>
                      </a:r>
                    </a:p>
                    <a:p>
                      <a:r>
                        <a:rPr lang="en-US" sz="1600" dirty="0" err="1"/>
                        <a:t>Harv</a:t>
                      </a:r>
                      <a:r>
                        <a:rPr lang="en-US" sz="1600" dirty="0"/>
                        <a:t>: 22</a:t>
                      </a:r>
                    </a:p>
                    <a:p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2-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5% Hu</a:t>
                      </a:r>
                    </a:p>
                    <a:p>
                      <a:r>
                        <a:rPr lang="en-US" dirty="0"/>
                        <a:t>14% 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2% Hu</a:t>
                      </a:r>
                    </a:p>
                    <a:p>
                      <a:r>
                        <a:rPr lang="en-US" dirty="0"/>
                        <a:t>40% 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CRC307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/20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8-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 err="1"/>
                        <a:t>Inj</a:t>
                      </a:r>
                      <a:r>
                        <a:rPr lang="en-US" sz="1600" dirty="0"/>
                        <a:t>: 33</a:t>
                      </a:r>
                    </a:p>
                    <a:p>
                      <a:r>
                        <a:rPr lang="en-US" sz="1600" dirty="0" err="1"/>
                        <a:t>Harv</a:t>
                      </a:r>
                      <a:r>
                        <a:rPr lang="en-US" sz="1600" dirty="0"/>
                        <a:t>: 28</a:t>
                      </a:r>
                    </a:p>
                    <a:p>
                      <a:endParaRPr lang="en-US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3-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2%</a:t>
                      </a:r>
                      <a:r>
                        <a:rPr lang="en-US" baseline="0" dirty="0"/>
                        <a:t> Hu 28% 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55% Hu</a:t>
                      </a:r>
                    </a:p>
                    <a:p>
                      <a:r>
                        <a:rPr lang="en-US" dirty="0"/>
                        <a:t>69%</a:t>
                      </a:r>
                      <a:r>
                        <a:rPr lang="en-US" baseline="0" dirty="0"/>
                        <a:t> T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92074" y="6040036"/>
            <a:ext cx="45320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very bony, calcified tumor; slow-grower</a:t>
            </a:r>
          </a:p>
          <a:p>
            <a:r>
              <a:rPr lang="en-US" dirty="0"/>
              <a:t>#Fewer T cells and LNs in this HIS-BRGS cohort </a:t>
            </a:r>
          </a:p>
        </p:txBody>
      </p:sp>
    </p:spTree>
    <p:extLst>
      <p:ext uri="{BB962C8B-B14F-4D97-AF65-F5344CB8AC3E}">
        <p14:creationId xmlns:p14="http://schemas.microsoft.com/office/powerpoint/2010/main" val="1151725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920D16A-0F5C-A549-A67A-0F955C0217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009478"/>
              </p:ext>
            </p:extLst>
          </p:nvPr>
        </p:nvGraphicFramePr>
        <p:xfrm>
          <a:off x="559397" y="83372"/>
          <a:ext cx="8025206" cy="66912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83032">
                  <a:extLst>
                    <a:ext uri="{9D8B030D-6E8A-4147-A177-3AD203B41FA5}">
                      <a16:colId xmlns:a16="http://schemas.microsoft.com/office/drawing/2014/main" val="2299268799"/>
                    </a:ext>
                  </a:extLst>
                </a:gridCol>
                <a:gridCol w="677857">
                  <a:extLst>
                    <a:ext uri="{9D8B030D-6E8A-4147-A177-3AD203B41FA5}">
                      <a16:colId xmlns:a16="http://schemas.microsoft.com/office/drawing/2014/main" val="4052260204"/>
                    </a:ext>
                  </a:extLst>
                </a:gridCol>
                <a:gridCol w="802522">
                  <a:extLst>
                    <a:ext uri="{9D8B030D-6E8A-4147-A177-3AD203B41FA5}">
                      <a16:colId xmlns:a16="http://schemas.microsoft.com/office/drawing/2014/main" val="3980256058"/>
                    </a:ext>
                  </a:extLst>
                </a:gridCol>
                <a:gridCol w="677857">
                  <a:extLst>
                    <a:ext uri="{9D8B030D-6E8A-4147-A177-3AD203B41FA5}">
                      <a16:colId xmlns:a16="http://schemas.microsoft.com/office/drawing/2014/main" val="3235833169"/>
                    </a:ext>
                  </a:extLst>
                </a:gridCol>
                <a:gridCol w="913515">
                  <a:extLst>
                    <a:ext uri="{9D8B030D-6E8A-4147-A177-3AD203B41FA5}">
                      <a16:colId xmlns:a16="http://schemas.microsoft.com/office/drawing/2014/main" val="121780868"/>
                    </a:ext>
                  </a:extLst>
                </a:gridCol>
                <a:gridCol w="948645">
                  <a:extLst>
                    <a:ext uri="{9D8B030D-6E8A-4147-A177-3AD203B41FA5}">
                      <a16:colId xmlns:a16="http://schemas.microsoft.com/office/drawing/2014/main" val="4212546328"/>
                    </a:ext>
                  </a:extLst>
                </a:gridCol>
                <a:gridCol w="851867">
                  <a:extLst>
                    <a:ext uri="{9D8B030D-6E8A-4147-A177-3AD203B41FA5}">
                      <a16:colId xmlns:a16="http://schemas.microsoft.com/office/drawing/2014/main" val="111394161"/>
                    </a:ext>
                  </a:extLst>
                </a:gridCol>
                <a:gridCol w="914197">
                  <a:extLst>
                    <a:ext uri="{9D8B030D-6E8A-4147-A177-3AD203B41FA5}">
                      <a16:colId xmlns:a16="http://schemas.microsoft.com/office/drawing/2014/main" val="3329201680"/>
                    </a:ext>
                  </a:extLst>
                </a:gridCol>
                <a:gridCol w="677857">
                  <a:extLst>
                    <a:ext uri="{9D8B030D-6E8A-4147-A177-3AD203B41FA5}">
                      <a16:colId xmlns:a16="http://schemas.microsoft.com/office/drawing/2014/main" val="613572185"/>
                    </a:ext>
                  </a:extLst>
                </a:gridCol>
                <a:gridCol w="677857">
                  <a:extLst>
                    <a:ext uri="{9D8B030D-6E8A-4147-A177-3AD203B41FA5}">
                      <a16:colId xmlns:a16="http://schemas.microsoft.com/office/drawing/2014/main" val="3928815845"/>
                    </a:ext>
                  </a:extLst>
                </a:gridCol>
              </a:tblGrid>
              <a:tr h="411911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2000" u="none" strike="noStrike" dirty="0">
                          <a:effectLst/>
                        </a:rPr>
                        <a:t>Supplemental Table III: Flow cytometric Abs and Reagents </a:t>
                      </a:r>
                    </a:p>
                  </a:txBody>
                  <a:tcPr marL="4270" marR="4270" marT="427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extLst>
                  <a:ext uri="{0D108BD9-81ED-4DB2-BD59-A6C34878D82A}">
                    <a16:rowId xmlns:a16="http://schemas.microsoft.com/office/drawing/2014/main" val="2407444081"/>
                  </a:ext>
                </a:extLst>
              </a:tr>
              <a:tr h="1745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Species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Target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Flurochrome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Clone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source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Species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Target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Flurochrome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Clone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 dirty="0">
                          <a:effectLst/>
                        </a:rPr>
                        <a:t>source</a:t>
                      </a:r>
                      <a:endParaRPr lang="en-US" sz="800" b="1" i="0" u="sng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497487178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UV3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PA-T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D Bioscie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LA-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V4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48-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BD Bioscienc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4214683654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UV39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D Bioscie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D5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V6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3G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609498161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ranzyme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QA16A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R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V65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1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857750002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T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BV78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PA-T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857757664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OKt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B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762818663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UCHT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ox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236A/E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789641693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PA-T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ox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259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710548483"/>
                  </a:ext>
                </a:extLst>
              </a:tr>
              <a:tr h="1745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63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ranzyme 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F64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B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774487775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-A2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anti-hum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D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EH12.2H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12016626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M3-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R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1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132614958"/>
                  </a:ext>
                </a:extLst>
              </a:tr>
              <a:tr h="1745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Epca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t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9C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97/ CCR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O43H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675406205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T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NF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ab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751429198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t8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LA-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L2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084764419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1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CRF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LA-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Fi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L2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075036619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63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Fi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PA-T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610468540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67.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CD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PCCY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30-F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066476759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97/ CCR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O43H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CR Bloc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ilteny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730002840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1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-hcl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ou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2.4G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064450188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R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UCH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Species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sng" strike="noStrike">
                          <a:effectLst/>
                        </a:rPr>
                        <a:t>source</a:t>
                      </a:r>
                      <a:endParaRPr lang="en-US" sz="800" b="1" i="0" u="sng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68963292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IM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38-2E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Zombie Gree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184961540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T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780 Ghost Dy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onb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476930564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Okt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ec Hu IL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&amp;D 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906595814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2H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ec Hu SC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&amp;D 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757132851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ec Hu FLT3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&amp;D syste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833076371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97/ CCR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O43H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CS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ibc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268278989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LA-AB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RC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W6/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CS CD34+ med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temce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19840285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 PeCy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T3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BS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ibc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104323316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1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Cy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CRF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MD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ibc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87860789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Cy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olgi Stop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D Bioscienc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034783827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F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eCy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4S.B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ell Stim Cocktai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nvitroge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677428324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1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ac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-hcl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aponi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ig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830423463"/>
                  </a:ext>
                </a:extLst>
              </a:tr>
              <a:tr h="253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ac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I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SA (Bovine serum Albumin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ig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2664946963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11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V4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-hcl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ormaldehyd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ish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extLst>
                  <a:ext uri="{0D108BD9-81ED-4DB2-BD59-A6C34878D82A}">
                    <a16:rowId xmlns:a16="http://schemas.microsoft.com/office/drawing/2014/main" val="3935559886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V4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M-A25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extLst>
                  <a:ext uri="{0D108BD9-81ED-4DB2-BD59-A6C34878D82A}">
                    <a16:rowId xmlns:a16="http://schemas.microsoft.com/office/drawing/2014/main" val="1961999215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D-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V4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29E.2A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extLst>
                  <a:ext uri="{0D108BD9-81ED-4DB2-BD59-A6C34878D82A}">
                    <a16:rowId xmlns:a16="http://schemas.microsoft.com/office/drawing/2014/main" val="3780693588"/>
                  </a:ext>
                </a:extLst>
              </a:tr>
              <a:tr h="128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ti-huma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IM-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V4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38-2E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iolege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270" marR="4270" marT="4270" marB="0" anchor="b"/>
                </a:tc>
                <a:extLst>
                  <a:ext uri="{0D108BD9-81ED-4DB2-BD59-A6C34878D82A}">
                    <a16:rowId xmlns:a16="http://schemas.microsoft.com/office/drawing/2014/main" val="17291159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2854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927" y="30183"/>
            <a:ext cx="5270302" cy="483545"/>
          </a:xfrm>
        </p:spPr>
        <p:txBody>
          <a:bodyPr>
            <a:normAutofit/>
          </a:bodyPr>
          <a:lstStyle/>
          <a:p>
            <a:pPr algn="l"/>
            <a:r>
              <a:rPr lang="en-US" sz="2000" dirty="0">
                <a:latin typeface="Calibri (Headings)"/>
                <a:cs typeface="Calibri (Headings)"/>
              </a:rPr>
              <a:t>Supplemental Figure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088059" y="3741788"/>
            <a:ext cx="1104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/>
              <a:t>CRC307M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69142" y="3741788"/>
            <a:ext cx="907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/>
              <a:t>CRC33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969142" y="908084"/>
            <a:ext cx="907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/>
              <a:t>CRC17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86738" y="908084"/>
            <a:ext cx="907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/>
              <a:t>CRC294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182628" y="1970804"/>
            <a:ext cx="8574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dirty="0"/>
              <a:t>All PDX</a:t>
            </a:r>
          </a:p>
        </p:txBody>
      </p:sp>
      <p:pic>
        <p:nvPicPr>
          <p:cNvPr id="4" name="Picture 3" descr="Copy of Prebleed Human T All-1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2091" y="2598788"/>
            <a:ext cx="2483922" cy="2286000"/>
          </a:xfrm>
          <a:prstGeom prst="rect">
            <a:avLst/>
          </a:prstGeom>
        </p:spPr>
      </p:pic>
      <p:pic>
        <p:nvPicPr>
          <p:cNvPr id="5" name="Picture 4" descr="Copy of Prebleed Human T TP#1 CRC172-1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92" y="1350596"/>
            <a:ext cx="2462601" cy="2286000"/>
          </a:xfrm>
          <a:prstGeom prst="rect">
            <a:avLst/>
          </a:prstGeom>
        </p:spPr>
      </p:pic>
      <p:pic>
        <p:nvPicPr>
          <p:cNvPr id="10" name="Picture 9" descr="Copy of Prebleed Human T TP#3 CRC294-1.pd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108" y="1350596"/>
            <a:ext cx="2483922" cy="2286000"/>
          </a:xfrm>
          <a:prstGeom prst="rect">
            <a:avLst/>
          </a:prstGeom>
        </p:spPr>
      </p:pic>
      <p:pic>
        <p:nvPicPr>
          <p:cNvPr id="11" name="Picture 10" descr="Copy of Prebleed Human T TP#4 CRC335-1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692" y="4016080"/>
            <a:ext cx="2462601" cy="2286000"/>
          </a:xfrm>
          <a:prstGeom prst="rect">
            <a:avLst/>
          </a:prstGeom>
        </p:spPr>
      </p:pic>
      <p:pic>
        <p:nvPicPr>
          <p:cNvPr id="12" name="Picture 11" descr="Copy of Prebleed Human T TP#5 307M-1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6108" y="4016080"/>
            <a:ext cx="2462601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3255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924653" y="2105616"/>
            <a:ext cx="3025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24279" y="1518430"/>
            <a:ext cx="338554" cy="2101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S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730536" y="2105616"/>
            <a:ext cx="45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S-W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296698" y="1518430"/>
            <a:ext cx="338554" cy="32364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FS-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186397" y="1518430"/>
            <a:ext cx="338554" cy="47204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mCD4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512919" y="2105616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CD4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64030" y="2105616"/>
            <a:ext cx="3256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ZG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042231" y="1518430"/>
            <a:ext cx="338554" cy="4369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hCD4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93911" y="1518430"/>
            <a:ext cx="338554" cy="37446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hCD3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230330" y="2105616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CD19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046344" y="2105616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CD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924080" y="2105616"/>
            <a:ext cx="583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hCD11c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602699" y="1035359"/>
            <a:ext cx="338554" cy="99565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/>
              <a:t>hCD11b, 14 or 33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68916" y="367932"/>
            <a:ext cx="605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plee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68916" y="1268091"/>
            <a:ext cx="598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umo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7ABBF5-85CA-5B48-885E-3C55CA4B3D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756" y="672257"/>
            <a:ext cx="723638" cy="685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4DEFEDC-DEC1-A441-8DDD-6C85055324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3984" y="672257"/>
            <a:ext cx="704719" cy="685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B66ACA-F5B4-2440-97DE-C61AEF80AC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25370" y="672257"/>
            <a:ext cx="723638" cy="685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E29A1CC-CF22-AE4C-8A16-DBB7A28FF3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64760" y="672257"/>
            <a:ext cx="704719" cy="6858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82CC7E6-89F9-7245-AF90-9C2BF331A45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15536" y="672257"/>
            <a:ext cx="704719" cy="6858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F51A36D-8119-A344-8428-9817F8A1C98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02899" y="672257"/>
            <a:ext cx="704719" cy="6858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149CAE0-A0A8-BF4A-B76A-A49DF26A443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66312" y="672257"/>
            <a:ext cx="704719" cy="685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51C1F08-9231-F34E-A37B-4A70EBB4711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41767" y="1480951"/>
            <a:ext cx="723638" cy="6858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4292EE2-0F13-1147-BED7-C5B41C6B2DE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58737" y="1480951"/>
            <a:ext cx="723638" cy="685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BD8796E-C590-7C44-946B-A9889348D2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64760" y="1480951"/>
            <a:ext cx="704719" cy="6858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E4E5109-DB75-CB40-88E0-B44C1D93759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413984" y="1480951"/>
            <a:ext cx="704719" cy="685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EEB829F-0AC3-1247-9665-6BE51702A0F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15536" y="1480951"/>
            <a:ext cx="704719" cy="6858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4C62056-3AE3-B24E-9D26-0E6AE2655DC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966312" y="1480951"/>
            <a:ext cx="690530" cy="6858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D91E306-25C8-7C47-BD54-78E11E3804C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802899" y="1480951"/>
            <a:ext cx="704719" cy="685800"/>
          </a:xfrm>
          <a:prstGeom prst="rect">
            <a:avLst/>
          </a:prstGeom>
        </p:spPr>
      </p:pic>
      <p:sp>
        <p:nvSpPr>
          <p:cNvPr id="32" name="Title 1"/>
          <p:cNvSpPr txBox="1">
            <a:spLocks/>
          </p:cNvSpPr>
          <p:nvPr/>
        </p:nvSpPr>
        <p:spPr>
          <a:xfrm>
            <a:off x="146767" y="30183"/>
            <a:ext cx="5270302" cy="483545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dirty="0">
                <a:latin typeface="Calibri (Headings)"/>
                <a:cs typeface="Calibri (Headings)"/>
              </a:rPr>
              <a:t>Supplemental Figure 2</a:t>
            </a:r>
          </a:p>
        </p:txBody>
      </p:sp>
      <p:grpSp>
        <p:nvGrpSpPr>
          <p:cNvPr id="34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586370" y="1818670"/>
            <a:ext cx="403968" cy="418496"/>
            <a:chOff x="1702333" y="1938864"/>
            <a:chExt cx="1260000" cy="1266931"/>
          </a:xfrm>
        </p:grpSpPr>
        <p:cxnSp>
          <p:nvCxnSpPr>
            <p:cNvPr id="37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8" name="TextBox 57"/>
          <p:cNvSpPr txBox="1"/>
          <p:nvPr/>
        </p:nvSpPr>
        <p:spPr>
          <a:xfrm>
            <a:off x="50687" y="37490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0687" y="242810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0687" y="403202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925354" y="2452065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D45+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836055" y="245206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TIL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941253" y="4210665"/>
            <a:ext cx="605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pleen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471557" y="4210665"/>
            <a:ext cx="34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N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719712" y="4210665"/>
            <a:ext cx="5968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CD3+ 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949549" y="4210665"/>
            <a:ext cx="674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CD45+</a:t>
            </a: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2963403" y="1140480"/>
            <a:ext cx="41738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3553806" y="799682"/>
            <a:ext cx="563439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4533229" y="902161"/>
            <a:ext cx="563439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>
            <a:off x="4336149" y="1287360"/>
            <a:ext cx="160510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1167097" y="962404"/>
            <a:ext cx="563439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/>
          <p:cNvCxnSpPr/>
          <p:nvPr/>
        </p:nvCxnSpPr>
        <p:spPr>
          <a:xfrm>
            <a:off x="1948824" y="1049519"/>
            <a:ext cx="41738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3" name="Picture 42" descr="Copy of Sup Fig 2Bi mCD45 cell # LN SP.pdf"/>
          <p:cNvPicPr>
            <a:picLocks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24" y="2831979"/>
            <a:ext cx="1371600" cy="1143000"/>
          </a:xfrm>
          <a:prstGeom prst="rect">
            <a:avLst/>
          </a:prstGeom>
        </p:spPr>
      </p:pic>
      <p:pic>
        <p:nvPicPr>
          <p:cNvPr id="45" name="Picture 44" descr="Copy of mCD45 cell # TIL Human T All-1.pdf"/>
          <p:cNvPicPr>
            <a:picLocks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151" y="2831979"/>
            <a:ext cx="1371600" cy="1143000"/>
          </a:xfrm>
          <a:prstGeom prst="rect">
            <a:avLst/>
          </a:prstGeom>
        </p:spPr>
      </p:pic>
      <p:pic>
        <p:nvPicPr>
          <p:cNvPr id="46" name="Picture 45" descr="Copy of Sup Fig 2Ci hCD45 cell # LN SP.pdf"/>
          <p:cNvPicPr>
            <a:picLocks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24" y="4532945"/>
            <a:ext cx="1371600" cy="1143000"/>
          </a:xfrm>
          <a:prstGeom prst="rect">
            <a:avLst/>
          </a:prstGeom>
        </p:spPr>
      </p:pic>
      <p:pic>
        <p:nvPicPr>
          <p:cNvPr id="47" name="Picture 46" descr="Copy of Sup Fig 2Cii hCD3 cell # LN SP-1.pdf"/>
          <p:cNvPicPr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2529" y="4532945"/>
            <a:ext cx="1371600" cy="1143000"/>
          </a:xfrm>
          <a:prstGeom prst="rect">
            <a:avLst/>
          </a:prstGeom>
        </p:spPr>
      </p:pic>
      <p:pic>
        <p:nvPicPr>
          <p:cNvPr id="48" name="Picture 47" descr="Copy of Sup Fig 2Ciii hCD4 8 cell # LN -1.pdf"/>
          <p:cNvPicPr>
            <a:picLocks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834" y="4532945"/>
            <a:ext cx="1371600" cy="1143000"/>
          </a:xfrm>
          <a:prstGeom prst="rect">
            <a:avLst/>
          </a:prstGeom>
        </p:spPr>
      </p:pic>
      <p:pic>
        <p:nvPicPr>
          <p:cNvPr id="49" name="Picture 48" descr="Copy of Sup Fig 2Civ hCD4 8 cell # SP-1.pdf"/>
          <p:cNvPicPr>
            <a:picLocks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3138" y="4537990"/>
            <a:ext cx="1371600" cy="1143000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793395" y="5631674"/>
            <a:ext cx="321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N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463753" y="563167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P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817328" y="3927277"/>
            <a:ext cx="321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N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1487686" y="392727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P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464214" y="5631674"/>
            <a:ext cx="321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N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134572" y="563167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P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4064624" y="563167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4+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4734982" y="563167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8+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658021" y="563167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4+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6328379" y="563167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CD8+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19080" y="3065833"/>
            <a:ext cx="369332" cy="43858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/>
              <a:t>Cell #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943821" y="2638404"/>
            <a:ext cx="369332" cy="102220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dirty="0"/>
              <a:t>Cell # per g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219080" y="4821002"/>
            <a:ext cx="369332" cy="43858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dirty="0"/>
              <a:t>Cell #</a:t>
            </a:r>
          </a:p>
        </p:txBody>
      </p:sp>
    </p:spTree>
    <p:extLst>
      <p:ext uri="{BB962C8B-B14F-4D97-AF65-F5344CB8AC3E}">
        <p14:creationId xmlns:p14="http://schemas.microsoft.com/office/powerpoint/2010/main" val="16259543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D3DE5996-C167-3B4B-8468-1013198535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191" y="1184897"/>
            <a:ext cx="1174531" cy="1143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1B3CB65E-428F-6F42-8FF8-08E32224C5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191" y="2486691"/>
            <a:ext cx="1174531" cy="1143000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75745" y="2777732"/>
            <a:ext cx="400110" cy="3895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/>
              <a:t>CD3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10546" y="3590537"/>
            <a:ext cx="73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LA-DR</a:t>
            </a: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58473" y="1184897"/>
            <a:ext cx="1167063" cy="11430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63238" y="2486691"/>
            <a:ext cx="1167063" cy="1143000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104828" y="555514"/>
            <a:ext cx="3385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604450" y="2673756"/>
            <a:ext cx="400110" cy="6822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/>
              <a:t>CD45R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562095" y="555514"/>
            <a:ext cx="3241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B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03261" y="3590537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CR7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965372" y="555514"/>
            <a:ext cx="3214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C</a:t>
            </a:r>
          </a:p>
        </p:txBody>
      </p:sp>
      <p:pic>
        <p:nvPicPr>
          <p:cNvPr id="55" name="Picture 5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24287" y="1184897"/>
            <a:ext cx="1167063" cy="1143000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24287" y="2486691"/>
            <a:ext cx="1167063" cy="1143000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>
            <a:off x="2965372" y="2820118"/>
            <a:ext cx="400110" cy="3895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/>
              <a:t>CD3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3530849" y="3590537"/>
            <a:ext cx="10640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Granzyme</a:t>
            </a:r>
            <a:r>
              <a:rPr lang="en-US" sz="1400" dirty="0"/>
              <a:t> B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402622" y="555514"/>
            <a:ext cx="3424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D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894664" y="555514"/>
            <a:ext cx="3099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E</a:t>
            </a:r>
          </a:p>
        </p:txBody>
      </p:sp>
      <p:pic>
        <p:nvPicPr>
          <p:cNvPr id="66" name="Picture 6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55914" y="1192962"/>
            <a:ext cx="1167063" cy="1143000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55914" y="2486691"/>
            <a:ext cx="1167063" cy="1143000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6647374" y="3590537"/>
            <a:ext cx="623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oxP3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5894664" y="2774620"/>
            <a:ext cx="400110" cy="4805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/>
              <a:t>CD25</a:t>
            </a:r>
          </a:p>
        </p:txBody>
      </p:sp>
      <p:pic>
        <p:nvPicPr>
          <p:cNvPr id="71" name="Picture 7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90101" y="1184897"/>
            <a:ext cx="1167063" cy="1143000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90101" y="2486691"/>
            <a:ext cx="1167063" cy="1143000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5186456" y="3590537"/>
            <a:ext cx="5838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TNF</a:t>
            </a:r>
            <a:r>
              <a:rPr lang="en-US" sz="1400" dirty="0" err="1">
                <a:latin typeface="Symbol" charset="2"/>
                <a:cs typeface="Symbol" charset="2"/>
              </a:rPr>
              <a:t>a</a:t>
            </a:r>
            <a:endParaRPr lang="en-US" sz="1400" dirty="0">
              <a:latin typeface="Symbol" charset="2"/>
              <a:cs typeface="Symbol" charset="2"/>
            </a:endParaRP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0CD102AB-A42B-FA40-A2EF-08405BB4A0D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5191" y="4043689"/>
            <a:ext cx="1174531" cy="1143000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3FCA604C-3740-094B-8AF9-83D5FD9DE2F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5191" y="5313743"/>
            <a:ext cx="1174531" cy="1143000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75745" y="4254398"/>
            <a:ext cx="400110" cy="48051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/>
              <a:t>CD19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-81782" y="5084576"/>
            <a:ext cx="615553" cy="114916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dirty="0"/>
              <a:t>CD11b, 11c, 14 or 33</a:t>
            </a:r>
          </a:p>
        </p:txBody>
      </p:sp>
      <p:pic>
        <p:nvPicPr>
          <p:cNvPr id="86" name="Picture 8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790101" y="3957386"/>
            <a:ext cx="1167063" cy="1143000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790101" y="5313743"/>
            <a:ext cx="1167063" cy="1143000"/>
          </a:xfrm>
          <a:prstGeom prst="rect">
            <a:avLst/>
          </a:prstGeom>
        </p:spPr>
      </p:pic>
      <p:sp>
        <p:nvSpPr>
          <p:cNvPr id="91" name="TextBox 90"/>
          <p:cNvSpPr txBox="1"/>
          <p:nvPr/>
        </p:nvSpPr>
        <p:spPr>
          <a:xfrm>
            <a:off x="5894664" y="4117882"/>
            <a:ext cx="430887" cy="787364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600" dirty="0"/>
              <a:t>PC </a:t>
            </a:r>
            <a:r>
              <a:rPr lang="en-US" sz="1600" dirty="0" err="1"/>
              <a:t>Unst</a:t>
            </a:r>
            <a:endParaRPr lang="en-US" sz="1600" dirty="0"/>
          </a:p>
        </p:txBody>
      </p:sp>
      <p:sp>
        <p:nvSpPr>
          <p:cNvPr id="92" name="TextBox 91"/>
          <p:cNvSpPr txBox="1"/>
          <p:nvPr/>
        </p:nvSpPr>
        <p:spPr>
          <a:xfrm>
            <a:off x="5894664" y="5499896"/>
            <a:ext cx="430887" cy="733845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600" dirty="0"/>
              <a:t>PC </a:t>
            </a:r>
            <a:r>
              <a:rPr lang="en-US" sz="1600" dirty="0" err="1"/>
              <a:t>Stim</a:t>
            </a:r>
            <a:endParaRPr lang="en-US" sz="1600" dirty="0"/>
          </a:p>
        </p:txBody>
      </p:sp>
      <p:sp>
        <p:nvSpPr>
          <p:cNvPr id="93" name="TextBox 92"/>
          <p:cNvSpPr txBox="1"/>
          <p:nvPr/>
        </p:nvSpPr>
        <p:spPr>
          <a:xfrm>
            <a:off x="75745" y="2830209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612753" y="90789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3+CD4+</a:t>
            </a:r>
          </a:p>
        </p:txBody>
      </p:sp>
      <p:grpSp>
        <p:nvGrpSpPr>
          <p:cNvPr id="75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306578" y="3347433"/>
            <a:ext cx="403968" cy="418496"/>
            <a:chOff x="1702333" y="1938864"/>
            <a:chExt cx="1260000" cy="1266931"/>
          </a:xfrm>
        </p:grpSpPr>
        <p:cxnSp>
          <p:nvCxnSpPr>
            <p:cNvPr id="94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7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1768101" y="3347433"/>
            <a:ext cx="403968" cy="418496"/>
            <a:chOff x="1702333" y="1938864"/>
            <a:chExt cx="1260000" cy="1266931"/>
          </a:xfrm>
        </p:grpSpPr>
        <p:cxnSp>
          <p:nvCxnSpPr>
            <p:cNvPr id="98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0" name="Title 1"/>
          <p:cNvSpPr>
            <a:spLocks noGrp="1"/>
          </p:cNvSpPr>
          <p:nvPr>
            <p:ph type="title"/>
          </p:nvPr>
        </p:nvSpPr>
        <p:spPr>
          <a:xfrm>
            <a:off x="94927" y="30183"/>
            <a:ext cx="5270302" cy="483545"/>
          </a:xfrm>
        </p:spPr>
        <p:txBody>
          <a:bodyPr>
            <a:normAutofit/>
          </a:bodyPr>
          <a:lstStyle/>
          <a:p>
            <a:pPr algn="l"/>
            <a:r>
              <a:rPr lang="en-US" sz="2000" dirty="0">
                <a:latin typeface="Calibri (Headings)"/>
                <a:cs typeface="Calibri (Headings)"/>
              </a:rPr>
              <a:t>Supplemental Figure 3</a:t>
            </a:r>
          </a:p>
        </p:txBody>
      </p:sp>
      <p:grpSp>
        <p:nvGrpSpPr>
          <p:cNvPr id="102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3186021" y="3347433"/>
            <a:ext cx="403968" cy="418496"/>
            <a:chOff x="1702333" y="1938864"/>
            <a:chExt cx="1260000" cy="1266931"/>
          </a:xfrm>
        </p:grpSpPr>
        <p:cxnSp>
          <p:nvCxnSpPr>
            <p:cNvPr id="103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5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4663130" y="3347433"/>
            <a:ext cx="403968" cy="418496"/>
            <a:chOff x="1702333" y="1938864"/>
            <a:chExt cx="1260000" cy="1266931"/>
          </a:xfrm>
        </p:grpSpPr>
        <p:cxnSp>
          <p:nvCxnSpPr>
            <p:cNvPr id="106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8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6126098" y="3347433"/>
            <a:ext cx="403968" cy="418496"/>
            <a:chOff x="1702333" y="1938864"/>
            <a:chExt cx="1260000" cy="1266931"/>
          </a:xfrm>
        </p:grpSpPr>
        <p:cxnSp>
          <p:nvCxnSpPr>
            <p:cNvPr id="109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1" name="TextBox 110"/>
          <p:cNvSpPr txBox="1"/>
          <p:nvPr/>
        </p:nvSpPr>
        <p:spPr>
          <a:xfrm>
            <a:off x="6489587" y="90789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3+CD4+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2113857" y="90789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3+CD4+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4928520" y="90789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3+CD8+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3481529" y="907898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D3+CD8+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7477690" y="1303834"/>
            <a:ext cx="430887" cy="653484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sz="1600" dirty="0"/>
              <a:t>Spleen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7477690" y="2611364"/>
            <a:ext cx="430887" cy="643766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sz="1600" dirty="0"/>
              <a:t>Tumor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756134" y="6476845"/>
            <a:ext cx="73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LA-DR</a:t>
            </a:r>
          </a:p>
        </p:txBody>
      </p:sp>
      <p:grpSp>
        <p:nvGrpSpPr>
          <p:cNvPr id="120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352166" y="6233741"/>
            <a:ext cx="403968" cy="418496"/>
            <a:chOff x="1702333" y="1938864"/>
            <a:chExt cx="1260000" cy="1266931"/>
          </a:xfrm>
        </p:grpSpPr>
        <p:cxnSp>
          <p:nvCxnSpPr>
            <p:cNvPr id="121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3" name="TextBox 122"/>
          <p:cNvSpPr txBox="1"/>
          <p:nvPr/>
        </p:nvSpPr>
        <p:spPr>
          <a:xfrm>
            <a:off x="4423015" y="2861144"/>
            <a:ext cx="400110" cy="4097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err="1"/>
              <a:t>IFN</a:t>
            </a:r>
            <a:r>
              <a:rPr lang="en-US" sz="1400" dirty="0" err="1">
                <a:latin typeface="Symbol" charset="2"/>
                <a:cs typeface="Symbol" charset="2"/>
              </a:rPr>
              <a:t>g</a:t>
            </a:r>
            <a:endParaRPr lang="en-US" sz="1400" dirty="0">
              <a:latin typeface="Symbol" charset="2"/>
              <a:cs typeface="Symbol" charset="2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539742" y="4251762"/>
            <a:ext cx="430887" cy="653484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sz="1600" dirty="0"/>
              <a:t>Spleen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1539742" y="5607628"/>
            <a:ext cx="430887" cy="653484"/>
          </a:xfrm>
          <a:prstGeom prst="rect">
            <a:avLst/>
          </a:prstGeom>
          <a:noFill/>
        </p:spPr>
        <p:txBody>
          <a:bodyPr vert="vert" wrap="none" rtlCol="0">
            <a:spAutoFit/>
          </a:bodyPr>
          <a:lstStyle/>
          <a:p>
            <a:r>
              <a:rPr lang="en-US" sz="1600" dirty="0"/>
              <a:t>Spleen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747405" y="3818886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 cells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690962" y="5100167"/>
            <a:ext cx="69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yeloid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186456" y="6476845"/>
            <a:ext cx="5838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TNF</a:t>
            </a:r>
            <a:r>
              <a:rPr lang="en-US" sz="1400" dirty="0" err="1">
                <a:latin typeface="Symbol" charset="2"/>
                <a:cs typeface="Symbol" charset="2"/>
              </a:rPr>
              <a:t>a</a:t>
            </a:r>
            <a:endParaRPr lang="en-US" sz="1400" dirty="0">
              <a:latin typeface="Symbol" charset="2"/>
              <a:cs typeface="Symbol" charset="2"/>
            </a:endParaRPr>
          </a:p>
        </p:txBody>
      </p:sp>
      <p:grpSp>
        <p:nvGrpSpPr>
          <p:cNvPr id="73" name="Grupo 48">
            <a:extLst>
              <a:ext uri="{FF2B5EF4-FFF2-40B4-BE49-F238E27FC236}">
                <a16:creationId xmlns:a16="http://schemas.microsoft.com/office/drawing/2014/main" id="{3E5E352A-634F-E049-96CF-18B2028D0A93}"/>
              </a:ext>
            </a:extLst>
          </p:cNvPr>
          <p:cNvGrpSpPr>
            <a:grpSpLocks noChangeAspect="1"/>
          </p:cNvGrpSpPr>
          <p:nvPr/>
        </p:nvGrpSpPr>
        <p:grpSpPr>
          <a:xfrm>
            <a:off x="4703917" y="6233741"/>
            <a:ext cx="403968" cy="418496"/>
            <a:chOff x="1702333" y="1938864"/>
            <a:chExt cx="1260000" cy="1266931"/>
          </a:xfrm>
        </p:grpSpPr>
        <p:cxnSp>
          <p:nvCxnSpPr>
            <p:cNvPr id="78" name="Conector recto de flecha 51">
              <a:extLst>
                <a:ext uri="{FF2B5EF4-FFF2-40B4-BE49-F238E27FC236}">
                  <a16:creationId xmlns:a16="http://schemas.microsoft.com/office/drawing/2014/main" id="{39A54A34-F2D5-F14F-AAF0-D8534E1D3EEB}"/>
                </a:ext>
              </a:extLst>
            </p:cNvPr>
            <p:cNvCxnSpPr/>
            <p:nvPr/>
          </p:nvCxnSpPr>
          <p:spPr>
            <a:xfrm>
              <a:off x="1702333" y="3205795"/>
              <a:ext cx="1260000" cy="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9" name="Conector recto de flecha 52">
              <a:extLst>
                <a:ext uri="{FF2B5EF4-FFF2-40B4-BE49-F238E27FC236}">
                  <a16:creationId xmlns:a16="http://schemas.microsoft.com/office/drawing/2014/main" id="{8D2B8560-A24E-764D-9D3E-6A50B2310D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6663" y="1938864"/>
              <a:ext cx="0" cy="1260000"/>
            </a:xfrm>
            <a:prstGeom prst="straightConnector1">
              <a:avLst/>
            </a:prstGeom>
            <a:ln w="12700">
              <a:miter lim="800000"/>
              <a:headEnd type="none"/>
              <a:tailEnd type="arrow" w="sm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2" name="TextBox 81"/>
          <p:cNvSpPr txBox="1"/>
          <p:nvPr/>
        </p:nvSpPr>
        <p:spPr>
          <a:xfrm>
            <a:off x="4423015" y="5744819"/>
            <a:ext cx="400110" cy="4097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err="1"/>
              <a:t>IFN</a:t>
            </a:r>
            <a:r>
              <a:rPr lang="en-US" sz="1400" dirty="0" err="1">
                <a:latin typeface="Symbol" charset="2"/>
                <a:cs typeface="Symbol" charset="2"/>
              </a:rPr>
              <a:t>g</a:t>
            </a:r>
            <a:endParaRPr lang="en-US" sz="1400" dirty="0">
              <a:latin typeface="Symbol" charset="2"/>
              <a:cs typeface="Symbol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1025398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B802CA5B-7645-E541-B7D3-1D3A0AC609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7320187"/>
              </p:ext>
            </p:extLst>
          </p:nvPr>
        </p:nvGraphicFramePr>
        <p:xfrm>
          <a:off x="133134" y="1139837"/>
          <a:ext cx="2892498" cy="176419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5367">
                  <a:extLst>
                    <a:ext uri="{9D8B030D-6E8A-4147-A177-3AD203B41FA5}">
                      <a16:colId xmlns:a16="http://schemas.microsoft.com/office/drawing/2014/main" val="568251945"/>
                    </a:ext>
                  </a:extLst>
                </a:gridCol>
                <a:gridCol w="452091">
                  <a:extLst>
                    <a:ext uri="{9D8B030D-6E8A-4147-A177-3AD203B41FA5}">
                      <a16:colId xmlns:a16="http://schemas.microsoft.com/office/drawing/2014/main" val="1924287937"/>
                    </a:ext>
                  </a:extLst>
                </a:gridCol>
                <a:gridCol w="429505">
                  <a:extLst>
                    <a:ext uri="{9D8B030D-6E8A-4147-A177-3AD203B41FA5}">
                      <a16:colId xmlns:a16="http://schemas.microsoft.com/office/drawing/2014/main" val="3588091142"/>
                    </a:ext>
                  </a:extLst>
                </a:gridCol>
                <a:gridCol w="446347">
                  <a:extLst>
                    <a:ext uri="{9D8B030D-6E8A-4147-A177-3AD203B41FA5}">
                      <a16:colId xmlns:a16="http://schemas.microsoft.com/office/drawing/2014/main" val="919717496"/>
                    </a:ext>
                  </a:extLst>
                </a:gridCol>
                <a:gridCol w="471905">
                  <a:extLst>
                    <a:ext uri="{9D8B030D-6E8A-4147-A177-3AD203B41FA5}">
                      <a16:colId xmlns:a16="http://schemas.microsoft.com/office/drawing/2014/main" val="2850413192"/>
                    </a:ext>
                  </a:extLst>
                </a:gridCol>
                <a:gridCol w="537283">
                  <a:extLst>
                    <a:ext uri="{9D8B030D-6E8A-4147-A177-3AD203B41FA5}">
                      <a16:colId xmlns:a16="http://schemas.microsoft.com/office/drawing/2014/main" val="2882707651"/>
                    </a:ext>
                  </a:extLst>
                </a:gridCol>
              </a:tblGrid>
              <a:tr h="345845">
                <a:tc>
                  <a:txBody>
                    <a:bodyPr/>
                    <a:lstStyle/>
                    <a:p>
                      <a:r>
                        <a:rPr lang="en-US" sz="900" dirty="0"/>
                        <a:t>Grou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# </a:t>
                      </a:r>
                    </a:p>
                    <a:p>
                      <a:r>
                        <a:rPr lang="en-US" sz="900" dirty="0" err="1"/>
                        <a:t>Injec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#  di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# low </a:t>
                      </a:r>
                      <a:r>
                        <a:rPr lang="en-US" sz="900" dirty="0" err="1"/>
                        <a:t>chim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#mice fin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/>
                        <a:t># tumo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6383216"/>
                  </a:ext>
                </a:extLst>
              </a:tr>
              <a:tr h="207834"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Ctr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0921607"/>
                  </a:ext>
                </a:extLst>
              </a:tr>
              <a:tr h="18406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err="1"/>
                        <a:t>Atezo</a:t>
                      </a: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8951545"/>
                  </a:ext>
                </a:extLst>
              </a:tr>
              <a:tr h="18406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Cob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9885348"/>
                  </a:ext>
                </a:extLst>
              </a:tr>
              <a:tr h="404933"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Co/A*#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6912559"/>
                  </a:ext>
                </a:extLst>
              </a:tr>
              <a:tr h="307705"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Ca/N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489186" y="737686"/>
            <a:ext cx="2179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RC307P: Tumor take rate = 98.1%</a:t>
            </a:r>
          </a:p>
        </p:txBody>
      </p:sp>
      <p:sp>
        <p:nvSpPr>
          <p:cNvPr id="3" name="Rectangle 2"/>
          <p:cNvSpPr/>
          <p:nvPr/>
        </p:nvSpPr>
        <p:spPr>
          <a:xfrm>
            <a:off x="533488" y="3088429"/>
            <a:ext cx="209785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000" dirty="0"/>
              <a:t>*1 tumor removed (very small)</a:t>
            </a:r>
          </a:p>
          <a:p>
            <a:pPr>
              <a:defRPr/>
            </a:pPr>
            <a:r>
              <a:rPr lang="en-US" sz="1000" dirty="0"/>
              <a:t># 1 mouse dying (limited data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2296" y="645353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52786" y="6905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6582" y="352072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398704" y="3520727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542735" y="3520727"/>
            <a:ext cx="297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94927" y="19425"/>
            <a:ext cx="5270302" cy="4835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dirty="0">
                <a:latin typeface="Calibri (Headings)"/>
                <a:cs typeface="Calibri (Headings)"/>
              </a:rPr>
              <a:t>Supplemental Figure 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845212" y="1049406"/>
            <a:ext cx="1005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umor weigh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304031" y="2017850"/>
            <a:ext cx="353943" cy="2462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(g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6359155" y="1049406"/>
            <a:ext cx="4206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G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5590680" y="1979378"/>
            <a:ext cx="353943" cy="3231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SG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827844" y="1049406"/>
            <a:ext cx="13003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HIS-CRC307P-BRG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154340" y="1526128"/>
            <a:ext cx="353943" cy="136191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Tumor Volume (mm3)</a:t>
            </a:r>
          </a:p>
        </p:txBody>
      </p:sp>
      <p:pic>
        <p:nvPicPr>
          <p:cNvPr id="8" name="Picture 7" descr="Tumor Grwoth Humanized CRC307P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283" y="1457307"/>
            <a:ext cx="2252673" cy="1592011"/>
          </a:xfrm>
          <a:prstGeom prst="rect">
            <a:avLst/>
          </a:prstGeom>
        </p:spPr>
      </p:pic>
      <p:pic>
        <p:nvPicPr>
          <p:cNvPr id="2" name="Picture 1" descr="Supp Fig 5B SGR TP#8.pdf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0635" y="1514239"/>
            <a:ext cx="1380744" cy="1371600"/>
          </a:xfrm>
          <a:prstGeom prst="rect">
            <a:avLst/>
          </a:prstGeom>
        </p:spPr>
      </p:pic>
      <p:pic>
        <p:nvPicPr>
          <p:cNvPr id="5" name="Picture 4" descr="Supp Fig 5B tumor weight TP#8-1.pdf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7974" y="1349647"/>
            <a:ext cx="1371600" cy="1536192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7058860" y="4027001"/>
            <a:ext cx="1871363" cy="1966497"/>
            <a:chOff x="269322" y="3997498"/>
            <a:chExt cx="1871363" cy="196649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865754" y="3997498"/>
              <a:ext cx="10951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mCD45+ Tumor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269322" y="5093399"/>
              <a:ext cx="353943" cy="19317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/>
                <a:t>%</a:t>
              </a:r>
            </a:p>
          </p:txBody>
        </p:sp>
        <p:pic>
          <p:nvPicPr>
            <p:cNvPr id="9" name="Picture 8" descr="Supp Fig 5Ci mCD45 TIL TP#8-1.pdf"/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6205" y="4601539"/>
              <a:ext cx="1554480" cy="1362456"/>
            </a:xfrm>
            <a:prstGeom prst="rect">
              <a:avLst/>
            </a:prstGeom>
          </p:spPr>
        </p:pic>
      </p:grpSp>
      <p:grpSp>
        <p:nvGrpSpPr>
          <p:cNvPr id="15" name="Group 14"/>
          <p:cNvGrpSpPr/>
          <p:nvPr/>
        </p:nvGrpSpPr>
        <p:grpSpPr>
          <a:xfrm>
            <a:off x="4755172" y="3501706"/>
            <a:ext cx="1953678" cy="3338701"/>
            <a:chOff x="4755172" y="3240096"/>
            <a:chExt cx="1953678" cy="3338701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5601698" y="3240096"/>
              <a:ext cx="63350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err="1"/>
                <a:t>pDC</a:t>
              </a:r>
              <a:r>
                <a:rPr lang="en-US" sz="1100" b="1" dirty="0"/>
                <a:t> TIL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5345217" y="4774186"/>
              <a:ext cx="11464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DR+ Myeloid TIL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4755172" y="3860577"/>
              <a:ext cx="353943" cy="6181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 err="1"/>
                <a:t>Rel</a:t>
              </a:r>
              <a:r>
                <a:rPr lang="en-US" sz="1100" dirty="0"/>
                <a:t> Cell #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4755172" y="5779049"/>
              <a:ext cx="353943" cy="193172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/>
                <a:t>%</a:t>
              </a:r>
            </a:p>
          </p:txBody>
        </p:sp>
        <p:pic>
          <p:nvPicPr>
            <p:cNvPr id="17" name="Picture 16" descr="Supp Fig 5D # pDC TIL TP#8-1.pdf"/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09545" y="3471116"/>
              <a:ext cx="1600200" cy="1371600"/>
            </a:xfrm>
            <a:prstGeom prst="rect">
              <a:avLst/>
            </a:prstGeom>
          </p:spPr>
        </p:pic>
        <p:pic>
          <p:nvPicPr>
            <p:cNvPr id="21" name="Picture 20" descr="Supp Fig 5D DR+ Mye TIL TP#8-1.pdf"/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8650" y="5156905"/>
              <a:ext cx="1600200" cy="1421892"/>
            </a:xfrm>
            <a:prstGeom prst="rect">
              <a:avLst/>
            </a:prstGeom>
          </p:spPr>
        </p:pic>
      </p:grpSp>
      <p:grpSp>
        <p:nvGrpSpPr>
          <p:cNvPr id="16" name="Group 15"/>
          <p:cNvGrpSpPr/>
          <p:nvPr/>
        </p:nvGrpSpPr>
        <p:grpSpPr>
          <a:xfrm>
            <a:off x="2469489" y="4027001"/>
            <a:ext cx="1974475" cy="1966497"/>
            <a:chOff x="7026511" y="3997498"/>
            <a:chExt cx="1974475" cy="1966497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7026511" y="5033337"/>
              <a:ext cx="353943" cy="31329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/>
                <a:t>MFI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7909195" y="3997498"/>
              <a:ext cx="87716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PD-1 Tumor</a:t>
              </a:r>
            </a:p>
          </p:txBody>
        </p:sp>
        <p:pic>
          <p:nvPicPr>
            <p:cNvPr id="23" name="Picture 22" descr="Supp Fig 5E PD-1 MFI Tum TP#8-1.pd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49230" y="4318075"/>
              <a:ext cx="1651756" cy="1645920"/>
            </a:xfrm>
            <a:prstGeom prst="rect">
              <a:avLst/>
            </a:prstGeom>
          </p:spPr>
        </p:pic>
      </p:grpSp>
      <p:sp>
        <p:nvSpPr>
          <p:cNvPr id="60" name="TextBox 59"/>
          <p:cNvSpPr txBox="1"/>
          <p:nvPr/>
        </p:nvSpPr>
        <p:spPr>
          <a:xfrm>
            <a:off x="6896051" y="3520727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429613" y="3501706"/>
            <a:ext cx="1669897" cy="3338701"/>
            <a:chOff x="2600162" y="3240096"/>
            <a:chExt cx="1669897" cy="3338701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2600162" y="3860577"/>
              <a:ext cx="353943" cy="6181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 err="1"/>
                <a:t>Rel</a:t>
              </a:r>
              <a:r>
                <a:rPr lang="en-US" sz="1100" dirty="0"/>
                <a:t> Cell #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3396388" y="3240096"/>
              <a:ext cx="5625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hCD4+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3396388" y="4774186"/>
              <a:ext cx="5625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hCD8+</a:t>
              </a:r>
            </a:p>
          </p:txBody>
        </p:sp>
        <p:pic>
          <p:nvPicPr>
            <p:cNvPr id="10" name="Picture 9" descr="Supp Fig 5Cii CD4 #  LN SP TP#8.pdf"/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80171" y="3562556"/>
              <a:ext cx="1389888" cy="1280160"/>
            </a:xfrm>
            <a:prstGeom prst="rect">
              <a:avLst/>
            </a:prstGeom>
          </p:spPr>
        </p:pic>
        <p:grpSp>
          <p:nvGrpSpPr>
            <p:cNvPr id="34" name="Group 33"/>
            <p:cNvGrpSpPr/>
            <p:nvPr/>
          </p:nvGrpSpPr>
          <p:grpSpPr>
            <a:xfrm>
              <a:off x="2880171" y="4975387"/>
              <a:ext cx="1383224" cy="1603410"/>
              <a:chOff x="3018064" y="4975387"/>
              <a:chExt cx="1383224" cy="1603410"/>
            </a:xfrm>
          </p:grpSpPr>
          <p:grpSp>
            <p:nvGrpSpPr>
              <p:cNvPr id="48" name="Group 47"/>
              <p:cNvGrpSpPr/>
              <p:nvPr/>
            </p:nvGrpSpPr>
            <p:grpSpPr>
              <a:xfrm>
                <a:off x="3220812" y="6317187"/>
                <a:ext cx="1127148" cy="261610"/>
                <a:chOff x="1846177" y="5970019"/>
                <a:chExt cx="1127148" cy="261610"/>
              </a:xfrm>
            </p:grpSpPr>
            <p:cxnSp>
              <p:nvCxnSpPr>
                <p:cNvPr id="49" name="Straight Connector 48"/>
                <p:cNvCxnSpPr/>
                <p:nvPr/>
              </p:nvCxnSpPr>
              <p:spPr>
                <a:xfrm>
                  <a:off x="1846177" y="6002583"/>
                  <a:ext cx="487374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2485951" y="6002583"/>
                  <a:ext cx="487374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1957659" y="5970019"/>
                  <a:ext cx="33502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LN</a:t>
                  </a: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2564394" y="5970019"/>
                  <a:ext cx="32235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/>
                    <a:t>SP</a:t>
                  </a:r>
                </a:p>
              </p:txBody>
            </p:sp>
          </p:grpSp>
          <p:pic>
            <p:nvPicPr>
              <p:cNvPr id="33" name="Picture 32" descr="Supp Fig 5Ciii CD8 #  LN SP TP#8-.pdf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18064" y="4975387"/>
                <a:ext cx="1383224" cy="1280160"/>
              </a:xfrm>
              <a:prstGeom prst="rect">
                <a:avLst/>
              </a:prstGeom>
            </p:spPr>
          </p:pic>
        </p:grp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CC7A506-C21C-1F4D-AB3D-E51A73BD4A76}"/>
                </a:ext>
              </a:extLst>
            </p:cNvPr>
            <p:cNvSpPr txBox="1"/>
            <p:nvPr/>
          </p:nvSpPr>
          <p:spPr>
            <a:xfrm>
              <a:off x="2600162" y="5332012"/>
              <a:ext cx="353943" cy="6181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100" dirty="0" err="1"/>
                <a:t>Rel</a:t>
              </a:r>
              <a:r>
                <a:rPr lang="en-US" sz="1100" dirty="0"/>
                <a:t> Cell #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340900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8375" y="240661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6" name="Title 1"/>
          <p:cNvSpPr txBox="1">
            <a:spLocks/>
          </p:cNvSpPr>
          <p:nvPr/>
        </p:nvSpPr>
        <p:spPr>
          <a:xfrm>
            <a:off x="94927" y="30183"/>
            <a:ext cx="5270302" cy="4835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dirty="0">
                <a:latin typeface="Calibri (Headings)"/>
                <a:cs typeface="Calibri (Headings)"/>
              </a:rPr>
              <a:t>Supplemental Figure 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1200125" y="450579"/>
            <a:ext cx="1056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CD45+ TI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375" y="5137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432219" y="1286946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89434" y="2132635"/>
            <a:ext cx="2775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V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362417" y="2132635"/>
            <a:ext cx="2757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717272" y="2132635"/>
            <a:ext cx="3274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Ca</a:t>
            </a:r>
            <a:endParaRPr lang="en-US" sz="1100" dirty="0"/>
          </a:p>
        </p:txBody>
      </p:sp>
      <p:sp>
        <p:nvSpPr>
          <p:cNvPr id="32" name="TextBox 31"/>
          <p:cNvSpPr txBox="1"/>
          <p:nvPr/>
        </p:nvSpPr>
        <p:spPr>
          <a:xfrm>
            <a:off x="2010321" y="2132635"/>
            <a:ext cx="4729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/>
              <a:t>Ca</a:t>
            </a:r>
            <a:r>
              <a:rPr lang="en-US" sz="1100" dirty="0"/>
              <a:t>/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21281" y="2580871"/>
            <a:ext cx="5625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/>
              <a:t>hCD4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877064" y="2667661"/>
            <a:ext cx="547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GrB</a:t>
            </a:r>
            <a:r>
              <a:rPr lang="en-US" sz="1400" dirty="0"/>
              <a:t>+</a:t>
            </a:r>
          </a:p>
        </p:txBody>
      </p:sp>
      <p:pic>
        <p:nvPicPr>
          <p:cNvPr id="7" name="Picture 6" descr="Copy of Sup Fig 7B P-1U Copy of Perc GrB+ CD4 TIL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64" y="3026598"/>
            <a:ext cx="1961647" cy="13716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21415" y="3365460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83817" y="3114980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32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324</a:t>
            </a:r>
          </a:p>
        </p:txBody>
      </p:sp>
      <p:pic>
        <p:nvPicPr>
          <p:cNvPr id="37" name="Picture 36" descr="Sup Fig 7B P-2U Copy of Perc Tem CD4 TIL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5686" y="3100652"/>
            <a:ext cx="1931981" cy="137160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121610" y="2667661"/>
            <a:ext cx="504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5365229" y="2667661"/>
            <a:ext cx="4914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Tcm</a:t>
            </a:r>
            <a:endParaRPr 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878412" y="2667661"/>
            <a:ext cx="620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IM-3</a:t>
            </a:r>
          </a:p>
        </p:txBody>
      </p:sp>
      <p:pic>
        <p:nvPicPr>
          <p:cNvPr id="41" name="Picture 40" descr="Sup Fig 7B P-3U Copy of Perc Tcm CD4 TIL.pd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5242" y="3153742"/>
            <a:ext cx="1931981" cy="1371600"/>
          </a:xfrm>
          <a:prstGeom prst="rect">
            <a:avLst/>
          </a:prstGeom>
        </p:spPr>
      </p:pic>
      <p:pic>
        <p:nvPicPr>
          <p:cNvPr id="43" name="Picture 42" descr="Sup Fig 7C P-2U Copy of Perc Tem CD8 TIL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5686" y="4616441"/>
            <a:ext cx="1931981" cy="1371600"/>
          </a:xfrm>
          <a:prstGeom prst="rect">
            <a:avLst/>
          </a:prstGeom>
        </p:spPr>
      </p:pic>
      <p:pic>
        <p:nvPicPr>
          <p:cNvPr id="44" name="Picture 43" descr="Sup Fig 7C P-3U Copy of Perc Tcm CD8 TIL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5242" y="4616441"/>
            <a:ext cx="1931981" cy="1371600"/>
          </a:xfrm>
          <a:prstGeom prst="rect">
            <a:avLst/>
          </a:prstGeom>
        </p:spPr>
      </p:pic>
      <p:pic>
        <p:nvPicPr>
          <p:cNvPr id="45" name="Picture 44" descr="Sup Fig 7C P-1U Copy of Perc GrB+ CD8 TIL.pd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30" y="4616441"/>
            <a:ext cx="1931981" cy="13716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21281" y="4353998"/>
            <a:ext cx="5625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/>
              <a:t>hCD8+</a:t>
            </a:r>
          </a:p>
        </p:txBody>
      </p:sp>
      <p:pic>
        <p:nvPicPr>
          <p:cNvPr id="47" name="Picture 46" descr="Sup Fig 7B P-4 Copy of Perc TIM3+ CD4 TIL.pd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4797" y="2982398"/>
            <a:ext cx="1931981" cy="1371600"/>
          </a:xfrm>
          <a:prstGeom prst="rect">
            <a:avLst/>
          </a:prstGeom>
        </p:spPr>
      </p:pic>
      <p:pic>
        <p:nvPicPr>
          <p:cNvPr id="48" name="Picture 47" descr="Sup Fig-7C P-4 Copy of Perc TIM3+ CD8 TIL.pdf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4797" y="4616441"/>
            <a:ext cx="1931981" cy="1371600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8276" y="5040277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478416" y="3114980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07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674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682263" y="3114980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09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63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8260581" y="3114980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R</a:t>
            </a:r>
            <a:r>
              <a:rPr lang="en-US" sz="900" b="1" baseline="30000" dirty="0"/>
              <a:t>2</a:t>
            </a:r>
            <a:r>
              <a:rPr lang="en-US" sz="900" b="1" dirty="0"/>
              <a:t>=0.149</a:t>
            </a:r>
          </a:p>
          <a:p>
            <a:r>
              <a:rPr lang="en-US" sz="900" b="1" dirty="0"/>
              <a:t>P=0.012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110765" y="3100652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362417" y="5233449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R</a:t>
            </a:r>
            <a:r>
              <a:rPr lang="en-US" sz="900" b="1" baseline="30000" dirty="0"/>
              <a:t>2</a:t>
            </a:r>
            <a:r>
              <a:rPr lang="en-US" sz="900" b="1" dirty="0"/>
              <a:t>=0.129</a:t>
            </a:r>
          </a:p>
          <a:p>
            <a:r>
              <a:rPr lang="en-US" sz="900" b="1" dirty="0"/>
              <a:t>P=0.044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212601" y="5228827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626513" y="5233449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24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37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856720" y="4633953"/>
            <a:ext cx="665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001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955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8110765" y="4633953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12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86</a:t>
            </a:r>
          </a:p>
        </p:txBody>
      </p:sp>
      <p:pic>
        <p:nvPicPr>
          <p:cNvPr id="62" name="Picture 61" descr="Copy of Sup 6A mCD45% out rem.pdf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6545" y="761035"/>
            <a:ext cx="1731146" cy="137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76540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itle 1"/>
          <p:cNvSpPr txBox="1">
            <a:spLocks/>
          </p:cNvSpPr>
          <p:nvPr/>
        </p:nvSpPr>
        <p:spPr>
          <a:xfrm>
            <a:off x="94927" y="30183"/>
            <a:ext cx="5270302" cy="4835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dirty="0">
                <a:latin typeface="Calibri (Headings)"/>
                <a:cs typeface="Calibri (Headings)"/>
              </a:rPr>
              <a:t>Supplemental Figure 6</a:t>
            </a:r>
          </a:p>
        </p:txBody>
      </p:sp>
      <p:pic>
        <p:nvPicPr>
          <p:cNvPr id="2" name="Picture 1" descr="S7A Cabo Perc hCD45+ of M+H TIL St A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515" y="826181"/>
            <a:ext cx="1463040" cy="976319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33369" y="1834040"/>
            <a:ext cx="5475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GrB</a:t>
            </a:r>
            <a:r>
              <a:rPr lang="en-US" sz="1400" dirty="0"/>
              <a:t>+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626294" y="441666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CD45+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0" y="1093774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12457" y="1803557"/>
            <a:ext cx="5625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/>
              <a:t>hCD4+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2080962" y="441666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CD3+ </a:t>
            </a:r>
          </a:p>
        </p:txBody>
      </p:sp>
      <p:pic>
        <p:nvPicPr>
          <p:cNvPr id="4" name="Picture 3" descr="S7A Cabo Perc T cell TIL St A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263" y="826181"/>
            <a:ext cx="1463040" cy="919852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443910" y="441666"/>
            <a:ext cx="9025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CD8+ (T)</a:t>
            </a:r>
          </a:p>
        </p:txBody>
      </p:sp>
      <p:pic>
        <p:nvPicPr>
          <p:cNvPr id="6" name="Picture 5" descr="S7A Cabo Perc hCD8+ of T TIL St A.pd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247" y="826181"/>
            <a:ext cx="1463040" cy="937639"/>
          </a:xfrm>
          <a:prstGeom prst="rect">
            <a:avLst/>
          </a:prstGeom>
        </p:spPr>
      </p:pic>
      <p:pic>
        <p:nvPicPr>
          <p:cNvPr id="8" name="Picture 7" descr="S7A Cabo Perc B cell of all TIL St A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7642" y="826181"/>
            <a:ext cx="1463040" cy="1003005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4965753" y="441666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CD19+</a:t>
            </a:r>
          </a:p>
        </p:txBody>
      </p:sp>
      <p:pic>
        <p:nvPicPr>
          <p:cNvPr id="9" name="Picture 8" descr="S7A myeloid of all TIL St A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5842" y="826181"/>
            <a:ext cx="1463040" cy="993597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6415786" y="441666"/>
            <a:ext cx="780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yeloid</a:t>
            </a:r>
          </a:p>
        </p:txBody>
      </p:sp>
      <p:pic>
        <p:nvPicPr>
          <p:cNvPr id="10" name="Picture 9" descr="S7A Cabo of Perc DR low of Myeloid TIL.pd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4146" y="826181"/>
            <a:ext cx="1463040" cy="919852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618072" y="441666"/>
            <a:ext cx="1560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LA-</a:t>
            </a:r>
            <a:r>
              <a:rPr lang="en-US" sz="1400" dirty="0" err="1"/>
              <a:t>DR</a:t>
            </a:r>
            <a:r>
              <a:rPr lang="en-US" sz="1400" baseline="30000" dirty="0" err="1"/>
              <a:t>lo</a:t>
            </a:r>
            <a:r>
              <a:rPr lang="en-US" sz="1400" baseline="30000" dirty="0"/>
              <a:t> </a:t>
            </a:r>
            <a:r>
              <a:rPr lang="en-US" sz="1400" dirty="0"/>
              <a:t>(Myeloid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12457" y="3215418"/>
            <a:ext cx="5625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/>
              <a:t>hCD8+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2164500" y="1834040"/>
            <a:ext cx="504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em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3649439" y="1834040"/>
            <a:ext cx="4914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Tcm</a:t>
            </a:r>
            <a:endParaRPr lang="en-US" sz="14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6495529" y="1834040"/>
            <a:ext cx="620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IM-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5079710" y="1834040"/>
            <a:ext cx="533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D-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857307" y="183404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IFN</a:t>
            </a:r>
            <a:r>
              <a:rPr lang="en-US" sz="1400" dirty="0" err="1">
                <a:latin typeface="Symbol" charset="2"/>
                <a:cs typeface="Symbol" charset="2"/>
              </a:rPr>
              <a:t>g</a:t>
            </a:r>
            <a:r>
              <a:rPr lang="en-US" sz="1400" dirty="0" err="1"/>
              <a:t>+TNF</a:t>
            </a:r>
            <a:r>
              <a:rPr lang="en-US" sz="1400" dirty="0" err="1">
                <a:latin typeface="Symbol" charset="2"/>
                <a:cs typeface="Symbol" charset="2"/>
              </a:rPr>
              <a:t>a</a:t>
            </a:r>
            <a:r>
              <a:rPr lang="en-US" sz="1400" dirty="0"/>
              <a:t>+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7693025" y="4724809"/>
            <a:ext cx="935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D4+ </a:t>
            </a:r>
            <a:r>
              <a:rPr lang="en-US" sz="1400" dirty="0" err="1"/>
              <a:t>Treg</a:t>
            </a:r>
            <a:endParaRPr lang="en-US" sz="1400" dirty="0"/>
          </a:p>
        </p:txBody>
      </p:sp>
      <p:pic>
        <p:nvPicPr>
          <p:cNvPr id="15" name="Picture 14" descr="S7B Cabo GrB+ CD4 TIL.pd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515" y="2313306"/>
            <a:ext cx="1426779" cy="914400"/>
          </a:xfrm>
          <a:prstGeom prst="rect">
            <a:avLst/>
          </a:prstGeom>
        </p:spPr>
      </p:pic>
      <p:pic>
        <p:nvPicPr>
          <p:cNvPr id="16" name="Picture 15" descr="S7B Cabo Perc IFNg+TNFa+ CD4 TIL.pdf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0407" y="2313306"/>
            <a:ext cx="1426779" cy="914400"/>
          </a:xfrm>
          <a:prstGeom prst="rect">
            <a:avLst/>
          </a:prstGeom>
        </p:spPr>
      </p:pic>
      <p:pic>
        <p:nvPicPr>
          <p:cNvPr id="17" name="Picture 16" descr="S7B Cabo Perc PD1+ CD4 TIL.pdf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6471" y="2313306"/>
            <a:ext cx="1426779" cy="914400"/>
          </a:xfrm>
          <a:prstGeom prst="rect">
            <a:avLst/>
          </a:prstGeom>
        </p:spPr>
      </p:pic>
      <p:pic>
        <p:nvPicPr>
          <p:cNvPr id="18" name="Picture 17" descr="S7B Cabo Perc Tcm CD4 TIL.pdf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247" y="2313306"/>
            <a:ext cx="1426779" cy="914400"/>
          </a:xfrm>
          <a:prstGeom prst="rect">
            <a:avLst/>
          </a:prstGeom>
        </p:spPr>
      </p:pic>
      <p:pic>
        <p:nvPicPr>
          <p:cNvPr id="20" name="Picture 19" descr="S7B Cabo Perc Tem CD4 TIL.pdf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263" y="2313306"/>
            <a:ext cx="1454369" cy="914400"/>
          </a:xfrm>
          <a:prstGeom prst="rect">
            <a:avLst/>
          </a:prstGeom>
        </p:spPr>
      </p:pic>
      <p:pic>
        <p:nvPicPr>
          <p:cNvPr id="21" name="Picture 20" descr="S7B Cabo Perc TIM3+ CD4 TIL.pdf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1882" y="2313306"/>
            <a:ext cx="1594705" cy="914400"/>
          </a:xfrm>
          <a:prstGeom prst="rect">
            <a:avLst/>
          </a:prstGeom>
        </p:spPr>
      </p:pic>
      <p:pic>
        <p:nvPicPr>
          <p:cNvPr id="22" name="Picture 21" descr="S7C  Cabo Perc IFNg+TNFa+ CD8 TIL.pdf"/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0407" y="3634472"/>
            <a:ext cx="1426779" cy="914400"/>
          </a:xfrm>
          <a:prstGeom prst="rect">
            <a:avLst/>
          </a:prstGeom>
        </p:spPr>
      </p:pic>
      <p:pic>
        <p:nvPicPr>
          <p:cNvPr id="41" name="Picture 40" descr="S7C Cabo  Perc TIM3+ CD8 TIL.pdf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1882" y="3634472"/>
            <a:ext cx="1554051" cy="1014896"/>
          </a:xfrm>
          <a:prstGeom prst="rect">
            <a:avLst/>
          </a:prstGeom>
        </p:spPr>
      </p:pic>
      <p:pic>
        <p:nvPicPr>
          <p:cNvPr id="79" name="Picture 78" descr="S7C Cabo PD1+ CD8 TIL.pdf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6471" y="3634472"/>
            <a:ext cx="1426779" cy="914400"/>
          </a:xfrm>
          <a:prstGeom prst="rect">
            <a:avLst/>
          </a:prstGeom>
        </p:spPr>
      </p:pic>
      <p:pic>
        <p:nvPicPr>
          <p:cNvPr id="80" name="Picture 79" descr="S7C Cabo Perc Tcm CD8 TIL.pdf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247" y="3634472"/>
            <a:ext cx="1426779" cy="914400"/>
          </a:xfrm>
          <a:prstGeom prst="rect">
            <a:avLst/>
          </a:prstGeom>
        </p:spPr>
      </p:pic>
      <p:pic>
        <p:nvPicPr>
          <p:cNvPr id="81" name="Picture 80" descr="S7C Cabo Perc Tem CD8 TIL.pdf"/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263" y="3634472"/>
            <a:ext cx="1454369" cy="914400"/>
          </a:xfrm>
          <a:prstGeom prst="rect">
            <a:avLst/>
          </a:prstGeom>
        </p:spPr>
      </p:pic>
      <p:pic>
        <p:nvPicPr>
          <p:cNvPr id="82" name="Picture 81" descr="S7C Cabo Perc GrB+ CD8 TIL.pdf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515" y="3634472"/>
            <a:ext cx="1454369" cy="914400"/>
          </a:xfrm>
          <a:prstGeom prst="rect">
            <a:avLst/>
          </a:prstGeom>
        </p:spPr>
      </p:pic>
      <p:pic>
        <p:nvPicPr>
          <p:cNvPr id="83" name="Picture 82" descr="S7B Cabo Perc Treg TIL.pdf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5041" y="5017247"/>
            <a:ext cx="2140169" cy="1371600"/>
          </a:xfrm>
          <a:prstGeom prst="rect">
            <a:avLst/>
          </a:prstGeom>
        </p:spPr>
      </p:pic>
      <p:pic>
        <p:nvPicPr>
          <p:cNvPr id="84" name="Picture 83" descr="S7D Cabo HLA-ABC MFI Tumor T St B.pdf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5017247"/>
            <a:ext cx="2140169" cy="1371600"/>
          </a:xfrm>
          <a:prstGeom prst="rect">
            <a:avLst/>
          </a:prstGeom>
        </p:spPr>
      </p:pic>
      <p:pic>
        <p:nvPicPr>
          <p:cNvPr id="85" name="Picture 84" descr="S7D Cabo HLA-DR MFI Tumor T St B out rem.pdf"/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7531" y="5017247"/>
            <a:ext cx="2331076" cy="1526912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666842" y="4724809"/>
            <a:ext cx="1149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LA-ABC MFI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-24572" y="2597600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-67002" y="3731271"/>
            <a:ext cx="353943" cy="1931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100" dirty="0"/>
              <a:t>%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1" y="5151353"/>
            <a:ext cx="353943" cy="7374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100" dirty="0"/>
              <a:t>Norm MFI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2915936" y="4724809"/>
            <a:ext cx="1060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HLA-DR MFI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5037197" y="4724809"/>
            <a:ext cx="9311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D-L1 MFI</a:t>
            </a:r>
          </a:p>
        </p:txBody>
      </p:sp>
      <p:pic>
        <p:nvPicPr>
          <p:cNvPr id="92" name="Picture 91" descr="S7D Cabo PD-L1 MFI Tumor T St B.pdf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5968" y="5017247"/>
            <a:ext cx="2140169" cy="1371600"/>
          </a:xfrm>
          <a:prstGeom prst="rect">
            <a:avLst/>
          </a:prstGeom>
        </p:spPr>
      </p:pic>
      <p:sp>
        <p:nvSpPr>
          <p:cNvPr id="94" name="TextBox 93">
            <a:extLst>
              <a:ext uri="{FF2B5EF4-FFF2-40B4-BE49-F238E27FC236}">
                <a16:creationId xmlns:a16="http://schemas.microsoft.com/office/drawing/2014/main" id="{ACC7A506-C21C-1F4D-AB3D-E51A73BD4A76}"/>
              </a:ext>
            </a:extLst>
          </p:cNvPr>
          <p:cNvSpPr txBox="1"/>
          <p:nvPr/>
        </p:nvSpPr>
        <p:spPr>
          <a:xfrm>
            <a:off x="81621" y="4627587"/>
            <a:ext cx="5693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u="sng" dirty="0"/>
              <a:t>Tumor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6606157" y="4724809"/>
            <a:ext cx="18275" cy="1664038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666243" y="5033957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83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136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692914" y="503395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62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203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443059" y="5033957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24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3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8176321" y="5033957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31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7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861195" y="3449806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124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199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365473" y="3449806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50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536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368684" y="3449806"/>
            <a:ext cx="683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625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07**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204194" y="3449806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14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554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6631111" y="3449806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R</a:t>
            </a:r>
            <a:r>
              <a:rPr lang="en-US" sz="900" baseline="30000" dirty="0">
                <a:solidFill>
                  <a:srgbClr val="000000"/>
                </a:solidFill>
              </a:rPr>
              <a:t>2</a:t>
            </a:r>
            <a:r>
              <a:rPr lang="en-US" sz="900" dirty="0">
                <a:solidFill>
                  <a:srgbClr val="000000"/>
                </a:solidFill>
              </a:rPr>
              <a:t>=0.110</a:t>
            </a:r>
          </a:p>
          <a:p>
            <a:r>
              <a:rPr lang="en-US" sz="900" dirty="0">
                <a:solidFill>
                  <a:srgbClr val="000000"/>
                </a:solidFill>
              </a:rPr>
              <a:t>P=0.085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7872391" y="3449806"/>
            <a:ext cx="622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354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19*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8297597" y="2138255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</a:rPr>
              <a:t>R</a:t>
            </a:r>
            <a:r>
              <a:rPr lang="en-US" sz="900" baseline="30000" dirty="0">
                <a:solidFill>
                  <a:srgbClr val="000000"/>
                </a:solidFill>
              </a:rPr>
              <a:t>2</a:t>
            </a:r>
            <a:r>
              <a:rPr lang="en-US" sz="900" dirty="0">
                <a:solidFill>
                  <a:srgbClr val="000000"/>
                </a:solidFill>
              </a:rPr>
              <a:t>=0.226</a:t>
            </a:r>
          </a:p>
          <a:p>
            <a:r>
              <a:rPr lang="en-US" sz="900" dirty="0">
                <a:solidFill>
                  <a:srgbClr val="000000"/>
                </a:solidFill>
              </a:rPr>
              <a:t>P=0.086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6812282" y="2138255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25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11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5508584" y="2138255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69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168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936063" y="2138255"/>
            <a:ext cx="625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527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17*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2365933" y="2138255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259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133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853934" y="2138255"/>
            <a:ext cx="622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296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36*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853934" y="749443"/>
            <a:ext cx="622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173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31*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2365933" y="749443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18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498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3707534" y="749443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45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276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5196795" y="749443"/>
            <a:ext cx="60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R</a:t>
            </a:r>
            <a:r>
              <a:rPr lang="en-US" sz="900" baseline="30000" dirty="0">
                <a:solidFill>
                  <a:schemeClr val="bg1">
                    <a:lumMod val="75000"/>
                  </a:schemeClr>
                </a:solidFill>
              </a:rPr>
              <a:t>2</a:t>
            </a:r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=0.078</a:t>
            </a:r>
          </a:p>
          <a:p>
            <a:r>
              <a:rPr lang="en-US" sz="900" dirty="0">
                <a:solidFill>
                  <a:schemeClr val="bg1">
                    <a:lumMod val="75000"/>
                  </a:schemeClr>
                </a:solidFill>
              </a:rPr>
              <a:t>P=0.168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6302688" y="749443"/>
            <a:ext cx="622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409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34*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7820705" y="749443"/>
            <a:ext cx="683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</a:rPr>
              <a:t>R</a:t>
            </a:r>
            <a:r>
              <a:rPr lang="en-US" sz="900" b="1" baseline="30000" dirty="0">
                <a:solidFill>
                  <a:srgbClr val="000000"/>
                </a:solidFill>
              </a:rPr>
              <a:t>2</a:t>
            </a:r>
            <a:r>
              <a:rPr lang="en-US" sz="900" b="1" dirty="0">
                <a:solidFill>
                  <a:srgbClr val="000000"/>
                </a:solidFill>
              </a:rPr>
              <a:t>=0..750</a:t>
            </a:r>
          </a:p>
          <a:p>
            <a:r>
              <a:rPr lang="en-US" sz="900" b="1" dirty="0">
                <a:solidFill>
                  <a:srgbClr val="000000"/>
                </a:solidFill>
              </a:rPr>
              <a:t>P=0.003**</a:t>
            </a:r>
          </a:p>
        </p:txBody>
      </p:sp>
      <p:sp>
        <p:nvSpPr>
          <p:cNvPr id="3" name="TextBox 88">
            <a:extLst>
              <a:ext uri="{FF2B5EF4-FFF2-40B4-BE49-F238E27FC236}">
                <a16:creationId xmlns:a16="http://schemas.microsoft.com/office/drawing/2014/main" id="{89D97BD7-487B-528A-6B2E-B4C2A9F751F5}"/>
              </a:ext>
            </a:extLst>
          </p:cNvPr>
          <p:cNvSpPr txBox="1"/>
          <p:nvPr/>
        </p:nvSpPr>
        <p:spPr>
          <a:xfrm rot="5400000">
            <a:off x="988152" y="6411122"/>
            <a:ext cx="353943" cy="34114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100" dirty="0"/>
              <a:t>SGR</a:t>
            </a:r>
          </a:p>
        </p:txBody>
      </p:sp>
      <p:cxnSp>
        <p:nvCxnSpPr>
          <p:cNvPr id="11" name="Conector recto de flecha 10">
            <a:extLst>
              <a:ext uri="{FF2B5EF4-FFF2-40B4-BE49-F238E27FC236}">
                <a16:creationId xmlns:a16="http://schemas.microsoft.com/office/drawing/2014/main" id="{B4751EFD-BB64-5F8C-C749-2737C9EEA5B7}"/>
              </a:ext>
            </a:extLst>
          </p:cNvPr>
          <p:cNvCxnSpPr>
            <a:stCxn id="3" idx="0"/>
          </p:cNvCxnSpPr>
          <p:nvPr/>
        </p:nvCxnSpPr>
        <p:spPr>
          <a:xfrm flipV="1">
            <a:off x="1335696" y="6581694"/>
            <a:ext cx="7603959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88">
            <a:extLst>
              <a:ext uri="{FF2B5EF4-FFF2-40B4-BE49-F238E27FC236}">
                <a16:creationId xmlns:a16="http://schemas.microsoft.com/office/drawing/2014/main" id="{BD87A7A4-CA19-2E81-2156-B4AB16F98A43}"/>
              </a:ext>
            </a:extLst>
          </p:cNvPr>
          <p:cNvSpPr txBox="1"/>
          <p:nvPr/>
        </p:nvSpPr>
        <p:spPr>
          <a:xfrm rot="5400000">
            <a:off x="4651798" y="6037873"/>
            <a:ext cx="307777" cy="12607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800" i="1" dirty="0"/>
              <a:t>(for all the X axes)</a:t>
            </a:r>
          </a:p>
        </p:txBody>
      </p:sp>
    </p:spTree>
    <p:extLst>
      <p:ext uri="{BB962C8B-B14F-4D97-AF65-F5344CB8AC3E}">
        <p14:creationId xmlns:p14="http://schemas.microsoft.com/office/powerpoint/2010/main" val="3063169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78</TotalTime>
  <Words>2325</Words>
  <Application>Microsoft Macintosh PowerPoint</Application>
  <PresentationFormat>Presentación en pantalla (4:3)</PresentationFormat>
  <Paragraphs>710</Paragraphs>
  <Slides>9</Slides>
  <Notes>8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(Headings)</vt:lpstr>
      <vt:lpstr>Symbol</vt:lpstr>
      <vt:lpstr>Times New Roman</vt:lpstr>
      <vt:lpstr>Office Theme</vt:lpstr>
      <vt:lpstr>Supplemental Table I: PDX Information </vt:lpstr>
      <vt:lpstr>Supplemental Table II: Experimental Details</vt:lpstr>
      <vt:lpstr>Presentación de PowerPoint</vt:lpstr>
      <vt:lpstr>Supplemental Figure 1</vt:lpstr>
      <vt:lpstr>Presentación de PowerPoint</vt:lpstr>
      <vt:lpstr>Supplemental Figure 3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Tumor Growth Curves</dc:title>
  <dc:creator>Julie Lang</dc:creator>
  <cp:lastModifiedBy>Alejandro Marín Jiménez</cp:lastModifiedBy>
  <cp:revision>240</cp:revision>
  <dcterms:created xsi:type="dcterms:W3CDTF">2020-04-23T16:31:00Z</dcterms:created>
  <dcterms:modified xsi:type="dcterms:W3CDTF">2022-09-21T20:21:29Z</dcterms:modified>
</cp:coreProperties>
</file>